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65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33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113A9D2-9D6B-4929-AA2D-F23B5EE8CBE7}" styleName="Estilo temático 2 - Énfasis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3" autoAdjust="0"/>
    <p:restoredTop sz="94660"/>
  </p:normalViewPr>
  <p:slideViewPr>
    <p:cSldViewPr snapToGrid="0">
      <p:cViewPr varScale="1">
        <p:scale>
          <a:sx n="76" d="100"/>
          <a:sy n="76" d="100"/>
        </p:scale>
        <p:origin x="137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ozal001\Desktop\Doctorado\2%20-%20Inhibidores%20Biologicos\Trigos%20-%20Mexico\Paper\Figuras\Datos%20Mexico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47-4CF0-9665-6DFFD9CD96B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F47-4CF0-9665-6DFFD9CD96B4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F47-4CF0-9665-6DFFD9CD96B4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5F47-4CF0-9665-6DFFD9CD96B4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F47-4CF0-9665-6DFFD9CD96B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F47-4CF0-9665-6DFFD9CD96B4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F47-4CF0-9665-6DFFD9CD96B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F47-4CF0-9665-6DFFD9CD96B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5F47-4CF0-9665-6DFFD9CD96B4}"/>
                </c:ext>
              </c:extLst>
            </c:dLbl>
            <c:dLbl>
              <c:idx val="2"/>
              <c:layout>
                <c:manualLayout>
                  <c:x val="0"/>
                  <c:y val="-1.851851851851853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5F47-4CF0-9665-6DFFD9CD96B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5F47-4CF0-9665-6DFFD9CD96B4}"/>
                </c:ext>
              </c:extLst>
            </c:dLbl>
            <c:dLbl>
              <c:idx val="4"/>
              <c:layout>
                <c:manualLayout>
                  <c:x val="-8.3993738691872158E-17"/>
                  <c:y val="-4.669117647058823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5F47-4CF0-9665-6DFFD9CD96B4}"/>
                </c:ext>
              </c:extLst>
            </c:dLbl>
            <c:dLbl>
              <c:idx val="5"/>
              <c:layout>
                <c:manualLayout>
                  <c:x val="-1.0185067526415994E-16"/>
                  <c:y val="-3.703703703703705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5F47-4CF0-9665-6DFFD9CD96B4}"/>
                </c:ext>
              </c:extLst>
            </c:dLbl>
            <c:dLbl>
              <c:idx val="6"/>
              <c:layout>
                <c:manualLayout>
                  <c:x val="-2.7777777777778798E-3"/>
                  <c:y val="-5.092592592592592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5F47-4CF0-9665-6DFFD9CD96B4}"/>
                </c:ext>
              </c:extLst>
            </c:dLbl>
            <c:dLbl>
              <c:idx val="7"/>
              <c:layout>
                <c:manualLayout>
                  <c:x val="0"/>
                  <c:y val="-3.631535947712422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5F47-4CF0-9665-6DFFD9CD96B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M'!$Q$3:$Q$10</c:f>
                <c:numCache>
                  <c:formatCode>General</c:formatCode>
                  <c:ptCount val="8"/>
                  <c:pt idx="0">
                    <c:v>7844299.9117383063</c:v>
                  </c:pt>
                  <c:pt idx="1">
                    <c:v>20343201.86014634</c:v>
                  </c:pt>
                  <c:pt idx="2">
                    <c:v>25214794.255679183</c:v>
                  </c:pt>
                  <c:pt idx="3">
                    <c:v>7921463.7445650669</c:v>
                  </c:pt>
                  <c:pt idx="4">
                    <c:v>56091711.176075064</c:v>
                  </c:pt>
                  <c:pt idx="5">
                    <c:v>16677603.200287104</c:v>
                  </c:pt>
                  <c:pt idx="6">
                    <c:v>17457956.16065836</c:v>
                  </c:pt>
                  <c:pt idx="7">
                    <c:v>46684662.050688185</c:v>
                  </c:pt>
                </c:numCache>
              </c:numRef>
            </c:plus>
            <c:minus>
              <c:numRef>
                <c:f>'Bacterias M'!$Q$3:$Q$10</c:f>
                <c:numCache>
                  <c:formatCode>General</c:formatCode>
                  <c:ptCount val="8"/>
                  <c:pt idx="0">
                    <c:v>7844299.9117383063</c:v>
                  </c:pt>
                  <c:pt idx="1">
                    <c:v>20343201.86014634</c:v>
                  </c:pt>
                  <c:pt idx="2">
                    <c:v>25214794.255679183</c:v>
                  </c:pt>
                  <c:pt idx="3">
                    <c:v>7921463.7445650669</c:v>
                  </c:pt>
                  <c:pt idx="4">
                    <c:v>56091711.176075064</c:v>
                  </c:pt>
                  <c:pt idx="5">
                    <c:v>16677603.200287104</c:v>
                  </c:pt>
                  <c:pt idx="6">
                    <c:v>17457956.16065836</c:v>
                  </c:pt>
                  <c:pt idx="7">
                    <c:v>46684662.0506881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M'!$M$3:$O$10</c:f>
              <c:multiLvlStrCache>
                <c:ptCount val="8"/>
                <c:lvl>
                  <c:pt idx="0">
                    <c:v>Control</c:v>
                  </c:pt>
                  <c:pt idx="1">
                    <c:v>BNI</c:v>
                  </c:pt>
                  <c:pt idx="2">
                    <c:v>Control</c:v>
                  </c:pt>
                  <c:pt idx="3">
                    <c:v>BNI</c:v>
                  </c:pt>
                  <c:pt idx="4">
                    <c:v>Control</c:v>
                  </c:pt>
                  <c:pt idx="5">
                    <c:v>BNI</c:v>
                  </c:pt>
                  <c:pt idx="6">
                    <c:v>Control</c:v>
                  </c:pt>
                  <c:pt idx="7">
                    <c:v>BNI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M'!$P$3:$P$10</c:f>
              <c:numCache>
                <c:formatCode>0.00E+00</c:formatCode>
                <c:ptCount val="8"/>
                <c:pt idx="0">
                  <c:v>299571709.59222972</c:v>
                </c:pt>
                <c:pt idx="1">
                  <c:v>323128300.95575374</c:v>
                </c:pt>
                <c:pt idx="2">
                  <c:v>247709047.49300775</c:v>
                </c:pt>
                <c:pt idx="3">
                  <c:v>204438092.98565283</c:v>
                </c:pt>
                <c:pt idx="4">
                  <c:v>282289008.67114997</c:v>
                </c:pt>
                <c:pt idx="5">
                  <c:v>232562485.1059933</c:v>
                </c:pt>
                <c:pt idx="6">
                  <c:v>289768544.18170279</c:v>
                </c:pt>
                <c:pt idx="7">
                  <c:v>256857730.506957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F47-4CF0-9665-6DFFD9CD96B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509699072"/>
        <c:axId val="509695136"/>
      </c:barChart>
      <c:catAx>
        <c:axId val="509699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509695136"/>
        <c:crosses val="autoZero"/>
        <c:auto val="1"/>
        <c:lblAlgn val="ctr"/>
        <c:lblOffset val="100"/>
        <c:noMultiLvlLbl val="0"/>
      </c:catAx>
      <c:valAx>
        <c:axId val="509695136"/>
        <c:scaling>
          <c:orientation val="minMax"/>
          <c:max val="60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509699072"/>
        <c:crosses val="autoZero"/>
        <c:crossBetween val="between"/>
        <c:majorUnit val="200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A56-4595-8340-592E628CCB6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A56-4595-8340-592E628CCB64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A56-4595-8340-592E628CCB64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2A56-4595-8340-592E628CCB64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A56-4595-8340-592E628CCB6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A56-4595-8340-592E628CCB64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A56-4595-8340-592E628CCB64}"/>
              </c:ext>
            </c:extLst>
          </c:dPt>
          <c:dLbls>
            <c:dLbl>
              <c:idx val="0"/>
              <c:layout>
                <c:manualLayout>
                  <c:x val="0"/>
                  <c:y val="-3.866632634886870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A56-4595-8340-592E628CCB6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A56-4595-8340-592E628CCB64}"/>
                </c:ext>
              </c:extLst>
            </c:dLbl>
            <c:dLbl>
              <c:idx val="2"/>
              <c:layout>
                <c:manualLayout>
                  <c:x val="-7.6299215989093274E-17"/>
                  <c:y val="-1.388892412722946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A56-4595-8340-592E628CCB64}"/>
                </c:ext>
              </c:extLst>
            </c:dLbl>
            <c:dLbl>
              <c:idx val="3"/>
              <c:layout>
                <c:manualLayout>
                  <c:x val="0"/>
                  <c:y val="-5.718506099587615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2A56-4595-8340-592E628CCB64}"/>
                </c:ext>
              </c:extLst>
            </c:dLbl>
            <c:dLbl>
              <c:idx val="4"/>
              <c:layout>
                <c:manualLayout>
                  <c:x val="-1.5259843197818655E-16"/>
                  <c:y val="-0.1566656027506879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2A56-4595-8340-592E628CCB64}"/>
                </c:ext>
              </c:extLst>
            </c:dLbl>
            <c:dLbl>
              <c:idx val="5"/>
              <c:layout>
                <c:manualLayout>
                  <c:x val="1.5259843197818655E-16"/>
                  <c:y val="-1.933316317443435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2A56-4595-8340-592E628CCB64}"/>
                </c:ext>
              </c:extLst>
            </c:dLbl>
            <c:dLbl>
              <c:idx val="6"/>
              <c:layout>
                <c:manualLayout>
                  <c:x val="0"/>
                  <c:y val="-5.55555555555555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2A56-4595-8340-592E628CCB64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2A56-4595-8340-592E628CCB6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M'!$AC$3:$AC$10</c:f>
                <c:numCache>
                  <c:formatCode>General</c:formatCode>
                  <c:ptCount val="8"/>
                  <c:pt idx="0">
                    <c:v>2959477.5710649649</c:v>
                  </c:pt>
                  <c:pt idx="1">
                    <c:v>974108.26840482594</c:v>
                  </c:pt>
                  <c:pt idx="2">
                    <c:v>3546710.0881686308</c:v>
                  </c:pt>
                  <c:pt idx="3">
                    <c:v>5286401.2358863913</c:v>
                  </c:pt>
                  <c:pt idx="4">
                    <c:v>10759572.770122079</c:v>
                  </c:pt>
                  <c:pt idx="5">
                    <c:v>1462565.5407724031</c:v>
                  </c:pt>
                  <c:pt idx="6">
                    <c:v>4564218.5770785743</c:v>
                  </c:pt>
                  <c:pt idx="7">
                    <c:v>1300389.0951934375</c:v>
                  </c:pt>
                </c:numCache>
              </c:numRef>
            </c:plus>
            <c:minus>
              <c:numRef>
                <c:f>'Bacterias M'!$AC$3:$AC$10</c:f>
                <c:numCache>
                  <c:formatCode>General</c:formatCode>
                  <c:ptCount val="8"/>
                  <c:pt idx="0">
                    <c:v>2959477.5710649649</c:v>
                  </c:pt>
                  <c:pt idx="1">
                    <c:v>974108.26840482594</c:v>
                  </c:pt>
                  <c:pt idx="2">
                    <c:v>3546710.0881686308</c:v>
                  </c:pt>
                  <c:pt idx="3">
                    <c:v>5286401.2358863913</c:v>
                  </c:pt>
                  <c:pt idx="4">
                    <c:v>10759572.770122079</c:v>
                  </c:pt>
                  <c:pt idx="5">
                    <c:v>1462565.5407724031</c:v>
                  </c:pt>
                  <c:pt idx="6">
                    <c:v>4564218.5770785743</c:v>
                  </c:pt>
                  <c:pt idx="7">
                    <c:v>1300389.09519343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M'!$Y$3:$AA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M'!$AB$3:$AB$10</c:f>
              <c:numCache>
                <c:formatCode>0.00E+00</c:formatCode>
                <c:ptCount val="8"/>
                <c:pt idx="0">
                  <c:v>25430161.724584971</c:v>
                </c:pt>
                <c:pt idx="1">
                  <c:v>20013782.969322555</c:v>
                </c:pt>
                <c:pt idx="2">
                  <c:v>51501165.133819349</c:v>
                </c:pt>
                <c:pt idx="3">
                  <c:v>29605044.367567018</c:v>
                </c:pt>
                <c:pt idx="4">
                  <c:v>37854874.268872872</c:v>
                </c:pt>
                <c:pt idx="5">
                  <c:v>30049502.977079686</c:v>
                </c:pt>
                <c:pt idx="6">
                  <c:v>34358274.984550253</c:v>
                </c:pt>
                <c:pt idx="7">
                  <c:v>29501906.9476303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A56-4595-8340-592E628CCB6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509676768"/>
        <c:axId val="509678080"/>
      </c:barChart>
      <c:catAx>
        <c:axId val="5096767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09678080"/>
        <c:crosses val="autoZero"/>
        <c:auto val="1"/>
        <c:lblAlgn val="ctr"/>
        <c:lblOffset val="100"/>
        <c:noMultiLvlLbl val="0"/>
      </c:catAx>
      <c:valAx>
        <c:axId val="509678080"/>
        <c:scaling>
          <c:orientation val="minMax"/>
          <c:max val="6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509676768"/>
        <c:crosses val="autoZero"/>
        <c:crossBetween val="between"/>
        <c:majorUnit val="20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720-436B-BAAC-7375CACE5A6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720-436B-BAAC-7375CACE5A65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720-436B-BAAC-7375CACE5A65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1720-436B-BAAC-7375CACE5A65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720-436B-BAAC-7375CACE5A65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720-436B-BAAC-7375CACE5A65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720-436B-BAAC-7375CACE5A65}"/>
              </c:ext>
            </c:extLst>
          </c:dPt>
          <c:dLbls>
            <c:dLbl>
              <c:idx val="0"/>
              <c:layout>
                <c:manualLayout>
                  <c:x val="-4.1503267973856213E-3"/>
                  <c:y val="-4.417525252525258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720-436B-BAAC-7375CACE5A65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BC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720-436B-BAAC-7375CACE5A65}"/>
                </c:ext>
              </c:extLst>
            </c:dLbl>
            <c:dLbl>
              <c:idx val="2"/>
              <c:layout>
                <c:manualLayout>
                  <c:x val="0"/>
                  <c:y val="-4.417525252525252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1720-436B-BAAC-7375CACE5A65}"/>
                </c:ext>
              </c:extLst>
            </c:dLbl>
            <c:dLbl>
              <c:idx val="3"/>
              <c:layout>
                <c:manualLayout>
                  <c:x val="0"/>
                  <c:y val="-5.878787878787884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1720-436B-BAAC-7375CACE5A65}"/>
                </c:ext>
              </c:extLst>
            </c:dLbl>
            <c:dLbl>
              <c:idx val="4"/>
              <c:layout>
                <c:manualLayout>
                  <c:x val="-4.1503267973856213E-3"/>
                  <c:y val="-7.69696969696969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1720-436B-BAAC-7375CACE5A65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1720-436B-BAAC-7375CACE5A65}"/>
                </c:ext>
              </c:extLst>
            </c:dLbl>
            <c:dLbl>
              <c:idx val="6"/>
              <c:layout>
                <c:manualLayout>
                  <c:x val="0"/>
                  <c:y val="-3.703703703703703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1720-436B-BAAC-7375CACE5A65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C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1720-436B-BAAC-7375CACE5A6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M'!$AI$3:$AI$10</c:f>
                <c:numCache>
                  <c:formatCode>General</c:formatCode>
                  <c:ptCount val="8"/>
                  <c:pt idx="0">
                    <c:v>1447596.6651742912</c:v>
                  </c:pt>
                  <c:pt idx="1">
                    <c:v>499586.42413162265</c:v>
                  </c:pt>
                  <c:pt idx="2">
                    <c:v>1503270.6979580149</c:v>
                  </c:pt>
                  <c:pt idx="3">
                    <c:v>1391582.3200957435</c:v>
                  </c:pt>
                  <c:pt idx="4">
                    <c:v>2774046.1299864035</c:v>
                  </c:pt>
                  <c:pt idx="5">
                    <c:v>750099.25721003977</c:v>
                  </c:pt>
                  <c:pt idx="6">
                    <c:v>988879.80738400039</c:v>
                  </c:pt>
                  <c:pt idx="7">
                    <c:v>601261.38068147597</c:v>
                  </c:pt>
                </c:numCache>
              </c:numRef>
            </c:plus>
            <c:minus>
              <c:numRef>
                <c:f>'Bacterias M'!$AI$3:$AI$10</c:f>
                <c:numCache>
                  <c:formatCode>General</c:formatCode>
                  <c:ptCount val="8"/>
                  <c:pt idx="0">
                    <c:v>1447596.6651742912</c:v>
                  </c:pt>
                  <c:pt idx="1">
                    <c:v>499586.42413162265</c:v>
                  </c:pt>
                  <c:pt idx="2">
                    <c:v>1503270.6979580149</c:v>
                  </c:pt>
                  <c:pt idx="3">
                    <c:v>1391582.3200957435</c:v>
                  </c:pt>
                  <c:pt idx="4">
                    <c:v>2774046.1299864035</c:v>
                  </c:pt>
                  <c:pt idx="5">
                    <c:v>750099.25721003977</c:v>
                  </c:pt>
                  <c:pt idx="6">
                    <c:v>988879.80738400039</c:v>
                  </c:pt>
                  <c:pt idx="7">
                    <c:v>601261.380681475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M'!$AE$3:$AG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M'!$AH$3:$AH$10</c:f>
              <c:numCache>
                <c:formatCode>0.00E+00</c:formatCode>
                <c:ptCount val="8"/>
                <c:pt idx="0">
                  <c:v>13568046.101871811</c:v>
                </c:pt>
                <c:pt idx="1">
                  <c:v>9596655.8885011896</c:v>
                </c:pt>
                <c:pt idx="2">
                  <c:v>14792307.165250104</c:v>
                </c:pt>
                <c:pt idx="3">
                  <c:v>11806078.324799588</c:v>
                </c:pt>
                <c:pt idx="4">
                  <c:v>18324319.630107589</c:v>
                </c:pt>
                <c:pt idx="5">
                  <c:v>14408807.177211383</c:v>
                </c:pt>
                <c:pt idx="6">
                  <c:v>11688404.560453339</c:v>
                </c:pt>
                <c:pt idx="7">
                  <c:v>9376732.8720660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1720-436B-BAAC-7375CACE5A6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96857592"/>
        <c:axId val="496861856"/>
      </c:barChart>
      <c:catAx>
        <c:axId val="4968575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96861856"/>
        <c:crosses val="autoZero"/>
        <c:auto val="1"/>
        <c:lblAlgn val="ctr"/>
        <c:lblOffset val="100"/>
        <c:noMultiLvlLbl val="0"/>
      </c:catAx>
      <c:valAx>
        <c:axId val="496861856"/>
        <c:scaling>
          <c:orientation val="minMax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9685759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F6D-475C-B11D-F85EEFE241C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F6D-475C-B11D-F85EEFE241C0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F6D-475C-B11D-F85EEFE241C0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CF6D-475C-B11D-F85EEFE241C0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F6D-475C-B11D-F85EEFE241C0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F6D-475C-B11D-F85EEFE241C0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F6D-475C-B11D-F85EEFE241C0}"/>
              </c:ext>
            </c:extLst>
          </c:dPt>
          <c:dLbls>
            <c:dLbl>
              <c:idx val="0"/>
              <c:layout>
                <c:manualLayout>
                  <c:x val="0"/>
                  <c:y val="-3.848484848484854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F6D-475C-B11D-F85EEFE241C0}"/>
                </c:ext>
              </c:extLst>
            </c:dLbl>
            <c:dLbl>
              <c:idx val="1"/>
              <c:layout>
                <c:manualLayout>
                  <c:x val="-7.6088445638519489E-17"/>
                  <c:y val="-2.565656565656565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F6D-475C-B11D-F85EEFE241C0}"/>
                </c:ext>
              </c:extLst>
            </c:dLbl>
            <c:dLbl>
              <c:idx val="2"/>
              <c:layout>
                <c:manualLayout>
                  <c:x val="-7.6088445638519489E-17"/>
                  <c:y val="-3.491565656565656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CF6D-475C-B11D-F85EEFE241C0}"/>
                </c:ext>
              </c:extLst>
            </c:dLbl>
            <c:dLbl>
              <c:idx val="3"/>
              <c:layout>
                <c:manualLayout>
                  <c:x val="0"/>
                  <c:y val="-5.772727272727272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CF6D-475C-B11D-F85EEFE241C0}"/>
                </c:ext>
              </c:extLst>
            </c:dLbl>
            <c:dLbl>
              <c:idx val="4"/>
              <c:layout>
                <c:manualLayout>
                  <c:x val="0"/>
                  <c:y val="-3.848484848484848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CF6D-475C-B11D-F85EEFE241C0}"/>
                </c:ext>
              </c:extLst>
            </c:dLbl>
            <c:dLbl>
              <c:idx val="5"/>
              <c:layout>
                <c:manualLayout>
                  <c:x val="0"/>
                  <c:y val="-1.851851851851856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CF6D-475C-B11D-F85EEFE241C0}"/>
                </c:ext>
              </c:extLst>
            </c:dLbl>
            <c:dLbl>
              <c:idx val="6"/>
              <c:layout>
                <c:manualLayout>
                  <c:x val="-4.1503267973856213E-3"/>
                  <c:y val="-3.419191919191925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CF6D-475C-B11D-F85EEFE241C0}"/>
                </c:ext>
              </c:extLst>
            </c:dLbl>
            <c:dLbl>
              <c:idx val="7"/>
              <c:layout>
                <c:manualLayout>
                  <c:x val="0"/>
                  <c:y val="-5.131313131313137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CF6D-475C-B11D-F85EEFE241C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M'!$AO$3:$AO$10</c:f>
                <c:numCache>
                  <c:formatCode>General</c:formatCode>
                  <c:ptCount val="8"/>
                  <c:pt idx="0">
                    <c:v>1230063.0692311362</c:v>
                  </c:pt>
                  <c:pt idx="1">
                    <c:v>875594.5931188137</c:v>
                  </c:pt>
                  <c:pt idx="2">
                    <c:v>2278598.598718876</c:v>
                  </c:pt>
                  <c:pt idx="3">
                    <c:v>2053376.4357122323</c:v>
                  </c:pt>
                  <c:pt idx="4">
                    <c:v>2825967.7881187741</c:v>
                  </c:pt>
                  <c:pt idx="5">
                    <c:v>1314653.1254470544</c:v>
                  </c:pt>
                  <c:pt idx="6">
                    <c:v>2255989.4361553146</c:v>
                  </c:pt>
                  <c:pt idx="7">
                    <c:v>2526800.0045139934</c:v>
                  </c:pt>
                </c:numCache>
              </c:numRef>
            </c:plus>
            <c:minus>
              <c:numRef>
                <c:f>'Bacterias M'!$AO$3:$AO$10</c:f>
                <c:numCache>
                  <c:formatCode>General</c:formatCode>
                  <c:ptCount val="8"/>
                  <c:pt idx="0">
                    <c:v>1230063.0692311362</c:v>
                  </c:pt>
                  <c:pt idx="1">
                    <c:v>875594.5931188137</c:v>
                  </c:pt>
                  <c:pt idx="2">
                    <c:v>2278598.598718876</c:v>
                  </c:pt>
                  <c:pt idx="3">
                    <c:v>2053376.4357122323</c:v>
                  </c:pt>
                  <c:pt idx="4">
                    <c:v>2825967.7881187741</c:v>
                  </c:pt>
                  <c:pt idx="5">
                    <c:v>1314653.1254470544</c:v>
                  </c:pt>
                  <c:pt idx="6">
                    <c:v>2255989.4361553146</c:v>
                  </c:pt>
                  <c:pt idx="7">
                    <c:v>2526800.00451399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M'!$AK$3:$AM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M'!$AN$3:$AN$10</c:f>
              <c:numCache>
                <c:formatCode>0.00E+00</c:formatCode>
                <c:ptCount val="8"/>
                <c:pt idx="0">
                  <c:v>12374478.204491183</c:v>
                </c:pt>
                <c:pt idx="1">
                  <c:v>10997941.835586445</c:v>
                </c:pt>
                <c:pt idx="2">
                  <c:v>31167901.257779531</c:v>
                </c:pt>
                <c:pt idx="3">
                  <c:v>16122135.548983647</c:v>
                </c:pt>
                <c:pt idx="4">
                  <c:v>17234948.136180319</c:v>
                </c:pt>
                <c:pt idx="5">
                  <c:v>16512754.557035681</c:v>
                </c:pt>
                <c:pt idx="6">
                  <c:v>17026160.179466888</c:v>
                </c:pt>
                <c:pt idx="7">
                  <c:v>13945742.165968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CF6D-475C-B11D-F85EEFE241C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96858248"/>
        <c:axId val="496858576"/>
      </c:barChart>
      <c:catAx>
        <c:axId val="4968582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96858576"/>
        <c:crosses val="autoZero"/>
        <c:auto val="1"/>
        <c:lblAlgn val="ctr"/>
        <c:lblOffset val="100"/>
        <c:noMultiLvlLbl val="0"/>
      </c:catAx>
      <c:valAx>
        <c:axId val="496858576"/>
        <c:scaling>
          <c:orientation val="minMax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96858248"/>
        <c:crosses val="autoZero"/>
        <c:crossBetween val="between"/>
        <c:majorUnit val="10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E13-4A26-9883-0D75533E5A0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E13-4A26-9883-0D75533E5A0D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E13-4A26-9883-0D75533E5A0D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BE13-4A26-9883-0D75533E5A0D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E13-4A26-9883-0D75533E5A0D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E13-4A26-9883-0D75533E5A0D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E13-4A26-9883-0D75533E5A0D}"/>
              </c:ext>
            </c:extLst>
          </c:dPt>
          <c:dLbls>
            <c:dLbl>
              <c:idx val="0"/>
              <c:layout>
                <c:manualLayout>
                  <c:x val="-2.5462668816039986E-17"/>
                  <c:y val="-1.851851851851853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E13-4A26-9883-0D75533E5A0D}"/>
                </c:ext>
              </c:extLst>
            </c:dLbl>
            <c:dLbl>
              <c:idx val="1"/>
              <c:layout>
                <c:manualLayout>
                  <c:x val="-4.1996869345936079E-17"/>
                  <c:y val="-2.945261437908496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E13-4A26-9883-0D75533E5A0D}"/>
                </c:ext>
              </c:extLst>
            </c:dLbl>
            <c:dLbl>
              <c:idx val="2"/>
              <c:layout>
                <c:manualLayout>
                  <c:x val="0"/>
                  <c:y val="-3.352410130718958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BE13-4A26-9883-0D75533E5A0D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BE13-4A26-9883-0D75533E5A0D}"/>
                </c:ext>
              </c:extLst>
            </c:dLbl>
            <c:dLbl>
              <c:idx val="4"/>
              <c:layout>
                <c:manualLayout>
                  <c:x val="-1.0185067526415994E-16"/>
                  <c:y val="-1.851851851851856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BE13-4A26-9883-0D75533E5A0D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BE13-4A26-9883-0D75533E5A0D}"/>
                </c:ext>
              </c:extLst>
            </c:dLbl>
            <c:dLbl>
              <c:idx val="6"/>
              <c:layout>
                <c:manualLayout>
                  <c:x val="-4.5815295815295814E-3"/>
                  <c:y val="-2.426470588235294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BE13-4A26-9883-0D75533E5A0D}"/>
                </c:ext>
              </c:extLst>
            </c:dLbl>
            <c:dLbl>
              <c:idx val="7"/>
              <c:layout>
                <c:manualLayout>
                  <c:x val="0"/>
                  <c:y val="-1.556372549019607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BE13-4A26-9883-0D75533E5A0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R'!$Q$3:$Q$10</c:f>
                <c:numCache>
                  <c:formatCode>General</c:formatCode>
                  <c:ptCount val="8"/>
                  <c:pt idx="0">
                    <c:v>44189535.426942095</c:v>
                  </c:pt>
                  <c:pt idx="1">
                    <c:v>45177861.230752625</c:v>
                  </c:pt>
                  <c:pt idx="2">
                    <c:v>55065899.796947442</c:v>
                  </c:pt>
                  <c:pt idx="3">
                    <c:v>25700773.693189137</c:v>
                  </c:pt>
                  <c:pt idx="4">
                    <c:v>24529019.973287478</c:v>
                  </c:pt>
                  <c:pt idx="5">
                    <c:v>18336011.727823474</c:v>
                  </c:pt>
                  <c:pt idx="6">
                    <c:v>40525488.254138693</c:v>
                  </c:pt>
                  <c:pt idx="7">
                    <c:v>27211503.905064661</c:v>
                  </c:pt>
                </c:numCache>
              </c:numRef>
            </c:plus>
            <c:minus>
              <c:numRef>
                <c:f>'Bacterias R'!$Q$3:$Q$10</c:f>
                <c:numCache>
                  <c:formatCode>General</c:formatCode>
                  <c:ptCount val="8"/>
                  <c:pt idx="0">
                    <c:v>44189535.426942095</c:v>
                  </c:pt>
                  <c:pt idx="1">
                    <c:v>45177861.230752625</c:v>
                  </c:pt>
                  <c:pt idx="2">
                    <c:v>55065899.796947442</c:v>
                  </c:pt>
                  <c:pt idx="3">
                    <c:v>25700773.693189137</c:v>
                  </c:pt>
                  <c:pt idx="4">
                    <c:v>24529019.973287478</c:v>
                  </c:pt>
                  <c:pt idx="5">
                    <c:v>18336011.727823474</c:v>
                  </c:pt>
                  <c:pt idx="6">
                    <c:v>40525488.254138693</c:v>
                  </c:pt>
                  <c:pt idx="7">
                    <c:v>27211503.9050646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R'!$M$3:$O$10</c:f>
              <c:multiLvlStrCache>
                <c:ptCount val="8"/>
                <c:lvl>
                  <c:pt idx="0">
                    <c:v>Control</c:v>
                  </c:pt>
                  <c:pt idx="1">
                    <c:v>BNI</c:v>
                  </c:pt>
                  <c:pt idx="2">
                    <c:v>Control</c:v>
                  </c:pt>
                  <c:pt idx="3">
                    <c:v>BNI</c:v>
                  </c:pt>
                  <c:pt idx="4">
                    <c:v>Control</c:v>
                  </c:pt>
                  <c:pt idx="5">
                    <c:v>BNI</c:v>
                  </c:pt>
                  <c:pt idx="6">
                    <c:v>Control</c:v>
                  </c:pt>
                  <c:pt idx="7">
                    <c:v>BNI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R'!$P$3:$P$10</c:f>
              <c:numCache>
                <c:formatCode>0.00E+00</c:formatCode>
                <c:ptCount val="8"/>
                <c:pt idx="0">
                  <c:v>388126822.15221214</c:v>
                </c:pt>
                <c:pt idx="1">
                  <c:v>433759376.96246004</c:v>
                </c:pt>
                <c:pt idx="2">
                  <c:v>252293789.5410617</c:v>
                </c:pt>
                <c:pt idx="3">
                  <c:v>258946327.27583417</c:v>
                </c:pt>
                <c:pt idx="4">
                  <c:v>342276482.50001591</c:v>
                </c:pt>
                <c:pt idx="5">
                  <c:v>304334911.13100672</c:v>
                </c:pt>
                <c:pt idx="6">
                  <c:v>247256957.85864967</c:v>
                </c:pt>
                <c:pt idx="7">
                  <c:v>297765680.957869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BE13-4A26-9883-0D75533E5A0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88311568"/>
        <c:axId val="488304352"/>
      </c:barChart>
      <c:catAx>
        <c:axId val="488311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88304352"/>
        <c:crosses val="autoZero"/>
        <c:auto val="1"/>
        <c:lblAlgn val="ctr"/>
        <c:lblOffset val="100"/>
        <c:noMultiLvlLbl val="0"/>
      </c:catAx>
      <c:valAx>
        <c:axId val="488304352"/>
        <c:scaling>
          <c:orientation val="minMax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88311568"/>
        <c:crosses val="autoZero"/>
        <c:crossBetween val="between"/>
        <c:majorUnit val="200000000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E24-4705-8E33-74AD8064E9C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E24-4705-8E33-74AD8064E9C3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E24-4705-8E33-74AD8064E9C3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2E24-4705-8E33-74AD8064E9C3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E24-4705-8E33-74AD8064E9C3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E24-4705-8E33-74AD8064E9C3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E24-4705-8E33-74AD8064E9C3}"/>
              </c:ext>
            </c:extLst>
          </c:dPt>
          <c:dLbls>
            <c:dLbl>
              <c:idx val="0"/>
              <c:layout>
                <c:manualLayout>
                  <c:x val="0"/>
                  <c:y val="-3.222193862405725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E24-4705-8E33-74AD8064E9C3}"/>
                </c:ext>
              </c:extLst>
            </c:dLbl>
            <c:dLbl>
              <c:idx val="1"/>
              <c:layout>
                <c:manualLayout>
                  <c:x val="0"/>
                  <c:y val="-3.866632634886870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E24-4705-8E33-74AD8064E9C3}"/>
                </c:ext>
              </c:extLst>
            </c:dLbl>
            <c:dLbl>
              <c:idx val="2"/>
              <c:layout>
                <c:manualLayout>
                  <c:x val="0"/>
                  <c:y val="-0.1024809877876315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E24-4705-8E33-74AD8064E9C3}"/>
                </c:ext>
              </c:extLst>
            </c:dLbl>
            <c:dLbl>
              <c:idx val="3"/>
              <c:layout>
                <c:manualLayout>
                  <c:x val="-7.3494521355388143E-17"/>
                  <c:y val="-3.866632634886870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2E24-4705-8E33-74AD8064E9C3}"/>
                </c:ext>
              </c:extLst>
            </c:dLbl>
            <c:dLbl>
              <c:idx val="4"/>
              <c:layout>
                <c:manualLayout>
                  <c:x val="-7.3494521355388143E-17"/>
                  <c:y val="-4.248120090911535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2E24-4705-8E33-74AD8064E9C3}"/>
                </c:ext>
              </c:extLst>
            </c:dLbl>
            <c:dLbl>
              <c:idx val="5"/>
              <c:layout>
                <c:manualLayout>
                  <c:x val="-1.0185067526415994E-16"/>
                  <c:y val="-4.629629629629629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2E24-4705-8E33-74AD8064E9C3}"/>
                </c:ext>
              </c:extLst>
            </c:dLbl>
            <c:dLbl>
              <c:idx val="6"/>
              <c:layout>
                <c:manualLayout>
                  <c:x val="0"/>
                  <c:y val="-5.79994895233030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2E24-4705-8E33-74AD8064E9C3}"/>
                </c:ext>
              </c:extLst>
            </c:dLbl>
            <c:dLbl>
              <c:idx val="7"/>
              <c:layout>
                <c:manualLayout>
                  <c:x val="-1.4698904271077629E-16"/>
                  <c:y val="-8.940699961993338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2E24-4705-8E33-74AD8064E9C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R'!$E$3:$E$10</c:f>
                <c:numCache>
                  <c:formatCode>General</c:formatCode>
                  <c:ptCount val="8"/>
                  <c:pt idx="0">
                    <c:v>10134289.910511805</c:v>
                  </c:pt>
                  <c:pt idx="1">
                    <c:v>11377696.788086858</c:v>
                  </c:pt>
                  <c:pt idx="2">
                    <c:v>27262323.963308487</c:v>
                  </c:pt>
                  <c:pt idx="3">
                    <c:v>7752046.0907151289</c:v>
                  </c:pt>
                  <c:pt idx="4">
                    <c:v>7508035.5967965974</c:v>
                  </c:pt>
                  <c:pt idx="5">
                    <c:v>12374506.531982275</c:v>
                  </c:pt>
                  <c:pt idx="6">
                    <c:v>12527379.775401026</c:v>
                  </c:pt>
                  <c:pt idx="7">
                    <c:v>24273614.272003334</c:v>
                  </c:pt>
                </c:numCache>
              </c:numRef>
            </c:plus>
            <c:minus>
              <c:numRef>
                <c:f>'Bacterias R'!$E$3:$E$10</c:f>
                <c:numCache>
                  <c:formatCode>General</c:formatCode>
                  <c:ptCount val="8"/>
                  <c:pt idx="0">
                    <c:v>10134289.910511805</c:v>
                  </c:pt>
                  <c:pt idx="1">
                    <c:v>11377696.788086858</c:v>
                  </c:pt>
                  <c:pt idx="2">
                    <c:v>27262323.963308487</c:v>
                  </c:pt>
                  <c:pt idx="3">
                    <c:v>7752046.0907151289</c:v>
                  </c:pt>
                  <c:pt idx="4">
                    <c:v>7508035.5967965974</c:v>
                  </c:pt>
                  <c:pt idx="5">
                    <c:v>12374506.531982275</c:v>
                  </c:pt>
                  <c:pt idx="6">
                    <c:v>12527379.775401026</c:v>
                  </c:pt>
                  <c:pt idx="7">
                    <c:v>24273614.2720033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R'!$A$3:$C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R'!$D$3:$D$10</c:f>
              <c:numCache>
                <c:formatCode>0.00E+00</c:formatCode>
                <c:ptCount val="8"/>
                <c:pt idx="0">
                  <c:v>115030426.36829357</c:v>
                </c:pt>
                <c:pt idx="1">
                  <c:v>133759376.96246007</c:v>
                </c:pt>
                <c:pt idx="2">
                  <c:v>142930752.36609945</c:v>
                </c:pt>
                <c:pt idx="3">
                  <c:v>148477228.77598631</c:v>
                </c:pt>
                <c:pt idx="4">
                  <c:v>144982712.45270872</c:v>
                </c:pt>
                <c:pt idx="5">
                  <c:v>156265403.96960169</c:v>
                </c:pt>
                <c:pt idx="6">
                  <c:v>127078758.41041134</c:v>
                </c:pt>
                <c:pt idx="7">
                  <c:v>136547549.50427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E24-4705-8E33-74AD8064E9C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88329936"/>
        <c:axId val="488327640"/>
      </c:barChart>
      <c:catAx>
        <c:axId val="48832993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88327640"/>
        <c:crosses val="autoZero"/>
        <c:auto val="1"/>
        <c:lblAlgn val="ctr"/>
        <c:lblOffset val="100"/>
        <c:noMultiLvlLbl val="0"/>
      </c:catAx>
      <c:valAx>
        <c:axId val="488327640"/>
        <c:scaling>
          <c:orientation val="minMax"/>
          <c:max val="20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88329936"/>
        <c:crosses val="autoZero"/>
        <c:crossBetween val="between"/>
        <c:majorUnit val="50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AF9-464E-946D-01A9D515AA6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AF9-464E-946D-01A9D515AA63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AF9-464E-946D-01A9D515AA63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AAF9-464E-946D-01A9D515AA63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AF9-464E-946D-01A9D515AA63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AF9-464E-946D-01A9D515AA63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AF9-464E-946D-01A9D515AA63}"/>
              </c:ext>
            </c:extLst>
          </c:dPt>
          <c:dLbls>
            <c:dLbl>
              <c:idx val="0"/>
              <c:layout>
                <c:manualLayout>
                  <c:x val="0"/>
                  <c:y val="-4.489898989898995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AF9-464E-946D-01A9D515AA63}"/>
                </c:ext>
              </c:extLst>
            </c:dLbl>
            <c:dLbl>
              <c:idx val="1"/>
              <c:layout>
                <c:manualLayout>
                  <c:x val="-7.6088445638519489E-17"/>
                  <c:y val="-7.552171717171714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AF9-464E-946D-01A9D515AA63}"/>
                </c:ext>
              </c:extLst>
            </c:dLbl>
            <c:dLbl>
              <c:idx val="2"/>
              <c:layout>
                <c:manualLayout>
                  <c:x val="-7.6088445638519489E-17"/>
                  <c:y val="-3.848484848484854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AAF9-464E-946D-01A9D515AA63}"/>
                </c:ext>
              </c:extLst>
            </c:dLbl>
            <c:dLbl>
              <c:idx val="3"/>
              <c:layout>
                <c:manualLayout>
                  <c:x val="0"/>
                  <c:y val="-3.207070707070706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AAF9-464E-946D-01A9D515AA63}"/>
                </c:ext>
              </c:extLst>
            </c:dLbl>
            <c:dLbl>
              <c:idx val="4"/>
              <c:layout>
                <c:manualLayout>
                  <c:x val="0"/>
                  <c:y val="-3.240740740740741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AAF9-464E-946D-01A9D515AA63}"/>
                </c:ext>
              </c:extLst>
            </c:dLbl>
            <c:dLbl>
              <c:idx val="5"/>
              <c:layout>
                <c:manualLayout>
                  <c:x val="-1.0185067526415994E-16"/>
                  <c:y val="-4.166666666666666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AAF9-464E-946D-01A9D515AA63}"/>
                </c:ext>
              </c:extLst>
            </c:dLbl>
            <c:dLbl>
              <c:idx val="6"/>
              <c:layout>
                <c:manualLayout>
                  <c:x val="0"/>
                  <c:y val="-5.13131313131313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AAF9-464E-946D-01A9D515AA63}"/>
                </c:ext>
              </c:extLst>
            </c:dLbl>
            <c:dLbl>
              <c:idx val="7"/>
              <c:layout>
                <c:manualLayout>
                  <c:x val="0"/>
                  <c:y val="-7.055555555555555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AAF9-464E-946D-01A9D515AA6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M'!$E$3:$E$10</c:f>
                <c:numCache>
                  <c:formatCode>General</c:formatCode>
                  <c:ptCount val="8"/>
                  <c:pt idx="0">
                    <c:v>7844299.9117382756</c:v>
                  </c:pt>
                  <c:pt idx="1">
                    <c:v>20343201.860146403</c:v>
                  </c:pt>
                  <c:pt idx="2">
                    <c:v>7835294.3151076762</c:v>
                  </c:pt>
                  <c:pt idx="3">
                    <c:v>8464511.3940872382</c:v>
                  </c:pt>
                  <c:pt idx="4">
                    <c:v>4510584.8376780832</c:v>
                  </c:pt>
                  <c:pt idx="5">
                    <c:v>9461092.7418109942</c:v>
                  </c:pt>
                  <c:pt idx="6">
                    <c:v>14021376.181619076</c:v>
                  </c:pt>
                  <c:pt idx="7">
                    <c:v>15721318.922924545</c:v>
                  </c:pt>
                </c:numCache>
              </c:numRef>
            </c:plus>
            <c:minus>
              <c:numRef>
                <c:f>'Bacterias M'!$E$3:$E$10</c:f>
                <c:numCache>
                  <c:formatCode>General</c:formatCode>
                  <c:ptCount val="8"/>
                  <c:pt idx="0">
                    <c:v>7844299.9117382756</c:v>
                  </c:pt>
                  <c:pt idx="1">
                    <c:v>20343201.860146403</c:v>
                  </c:pt>
                  <c:pt idx="2">
                    <c:v>7835294.3151076762</c:v>
                  </c:pt>
                  <c:pt idx="3">
                    <c:v>8464511.3940872382</c:v>
                  </c:pt>
                  <c:pt idx="4">
                    <c:v>4510584.8376780832</c:v>
                  </c:pt>
                  <c:pt idx="5">
                    <c:v>9461092.7418109942</c:v>
                  </c:pt>
                  <c:pt idx="6">
                    <c:v>14021376.181619076</c:v>
                  </c:pt>
                  <c:pt idx="7">
                    <c:v>15721318.9229245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M'!$A$3:$C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M'!$D$3:$D$10</c:f>
              <c:numCache>
                <c:formatCode>0.00E+00</c:formatCode>
                <c:ptCount val="8"/>
                <c:pt idx="0">
                  <c:v>99571709.592229724</c:v>
                </c:pt>
                <c:pt idx="1">
                  <c:v>123128300.9557538</c:v>
                </c:pt>
                <c:pt idx="2">
                  <c:v>108661268.49916875</c:v>
                </c:pt>
                <c:pt idx="3">
                  <c:v>92066845.95574294</c:v>
                </c:pt>
                <c:pt idx="4">
                  <c:v>118109184.42223512</c:v>
                </c:pt>
                <c:pt idx="5">
                  <c:v>120658251.66735817</c:v>
                </c:pt>
                <c:pt idx="6">
                  <c:v>111238061.11137374</c:v>
                </c:pt>
                <c:pt idx="7">
                  <c:v>90165362.3511768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AAF9-464E-946D-01A9D515AA6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95562600"/>
        <c:axId val="495555056"/>
      </c:barChart>
      <c:catAx>
        <c:axId val="49556260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95555056"/>
        <c:crosses val="autoZero"/>
        <c:auto val="1"/>
        <c:lblAlgn val="ctr"/>
        <c:lblOffset val="100"/>
        <c:noMultiLvlLbl val="0"/>
      </c:catAx>
      <c:valAx>
        <c:axId val="495555056"/>
        <c:scaling>
          <c:orientation val="minMax"/>
          <c:max val="20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95562600"/>
        <c:crosses val="autoZero"/>
        <c:crossBetween val="between"/>
        <c:majorUnit val="50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F64-48F4-BA4F-067A8DD8267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F64-48F4-BA4F-067A8DD82674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F64-48F4-BA4F-067A8DD82674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8F64-48F4-BA4F-067A8DD82674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F64-48F4-BA4F-067A8DD8267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F64-48F4-BA4F-067A8DD82674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F64-48F4-BA4F-067A8DD8267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F64-48F4-BA4F-067A8DD8267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C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F64-48F4-BA4F-067A8DD8267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8F64-48F4-BA4F-067A8DD82674}"/>
                </c:ext>
              </c:extLst>
            </c:dLbl>
            <c:dLbl>
              <c:idx val="3"/>
              <c:layout>
                <c:manualLayout>
                  <c:x val="0"/>
                  <c:y val="4.6296296296296346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8F64-48F4-BA4F-067A8DD82674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F64-48F4-BA4F-067A8DD82674}"/>
                </c:ext>
              </c:extLst>
            </c:dLbl>
            <c:dLbl>
              <c:idx val="5"/>
              <c:layout>
                <c:manualLayout>
                  <c:x val="-1.0185067526415994E-16"/>
                  <c:y val="-4.166666666666668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8F64-48F4-BA4F-067A8DD82674}"/>
                </c:ext>
              </c:extLst>
            </c:dLbl>
            <c:dLbl>
              <c:idx val="6"/>
              <c:layout>
                <c:manualLayout>
                  <c:x val="-1.0185067526415994E-16"/>
                  <c:y val="-1.851851851851853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8F64-48F4-BA4F-067A8DD82674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8F64-48F4-BA4F-067A8DD8267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M'!$AU$3:$AU$10</c:f>
                <c:numCache>
                  <c:formatCode>General</c:formatCode>
                  <c:ptCount val="8"/>
                  <c:pt idx="0">
                    <c:v>458884.36434862111</c:v>
                  </c:pt>
                  <c:pt idx="1">
                    <c:v>142259.58409008491</c:v>
                  </c:pt>
                  <c:pt idx="2">
                    <c:v>403568.78555779485</c:v>
                  </c:pt>
                  <c:pt idx="3">
                    <c:v>398278.46562740067</c:v>
                  </c:pt>
                  <c:pt idx="4">
                    <c:v>626488.2681407436</c:v>
                  </c:pt>
                  <c:pt idx="5">
                    <c:v>213594.29160322424</c:v>
                  </c:pt>
                  <c:pt idx="6">
                    <c:v>526356.86178084672</c:v>
                  </c:pt>
                  <c:pt idx="7">
                    <c:v>944555.80247174064</c:v>
                  </c:pt>
                </c:numCache>
              </c:numRef>
            </c:plus>
            <c:minus>
              <c:numRef>
                <c:f>'Bacterias M'!$AU$3:$AU$10</c:f>
                <c:numCache>
                  <c:formatCode>General</c:formatCode>
                  <c:ptCount val="8"/>
                  <c:pt idx="0">
                    <c:v>458884.36434862111</c:v>
                  </c:pt>
                  <c:pt idx="1">
                    <c:v>142259.58409008491</c:v>
                  </c:pt>
                  <c:pt idx="2">
                    <c:v>403568.78555779485</c:v>
                  </c:pt>
                  <c:pt idx="3">
                    <c:v>398278.46562740067</c:v>
                  </c:pt>
                  <c:pt idx="4">
                    <c:v>626488.2681407436</c:v>
                  </c:pt>
                  <c:pt idx="5">
                    <c:v>213594.29160322424</c:v>
                  </c:pt>
                  <c:pt idx="6">
                    <c:v>526356.86178084672</c:v>
                  </c:pt>
                  <c:pt idx="7">
                    <c:v>944555.802471740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M'!$AQ$3:$AS$10</c:f>
              <c:multiLvlStrCache>
                <c:ptCount val="8"/>
                <c:lvl>
                  <c:pt idx="0">
                    <c:v>Control</c:v>
                  </c:pt>
                  <c:pt idx="1">
                    <c:v>BNI</c:v>
                  </c:pt>
                  <c:pt idx="2">
                    <c:v>Control</c:v>
                  </c:pt>
                  <c:pt idx="3">
                    <c:v>BNI</c:v>
                  </c:pt>
                  <c:pt idx="4">
                    <c:v>Control</c:v>
                  </c:pt>
                  <c:pt idx="5">
                    <c:v>BNI</c:v>
                  </c:pt>
                  <c:pt idx="6">
                    <c:v>Control</c:v>
                  </c:pt>
                  <c:pt idx="7">
                    <c:v>BNI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M'!$AT$3:$AT$10</c:f>
              <c:numCache>
                <c:formatCode>0.00E+00</c:formatCode>
                <c:ptCount val="8"/>
                <c:pt idx="0">
                  <c:v>5044102.1323164105</c:v>
                </c:pt>
                <c:pt idx="1">
                  <c:v>3520880.0998242861</c:v>
                </c:pt>
                <c:pt idx="2">
                  <c:v>8171486.592729969</c:v>
                </c:pt>
                <c:pt idx="3">
                  <c:v>8464084.8670193572</c:v>
                </c:pt>
                <c:pt idx="4">
                  <c:v>5906807.9434095593</c:v>
                </c:pt>
                <c:pt idx="5">
                  <c:v>5286391.7433192674</c:v>
                </c:pt>
                <c:pt idx="6">
                  <c:v>7726770.508938876</c:v>
                </c:pt>
                <c:pt idx="7">
                  <c:v>5967608.7671457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8F64-48F4-BA4F-067A8DD8267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96833976"/>
        <c:axId val="496859232"/>
      </c:barChart>
      <c:catAx>
        <c:axId val="49683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96859232"/>
        <c:crosses val="autoZero"/>
        <c:auto val="1"/>
        <c:lblAlgn val="ctr"/>
        <c:lblOffset val="100"/>
        <c:noMultiLvlLbl val="0"/>
      </c:catAx>
      <c:valAx>
        <c:axId val="496859232"/>
        <c:scaling>
          <c:orientation val="minMax"/>
          <c:max val="2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96833976"/>
        <c:crosses val="autoZero"/>
        <c:crossBetween val="between"/>
        <c:majorUnit val="4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B22-407D-9A5F-AFFFD54529D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B22-407D-9A5F-AFFFD54529D3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B22-407D-9A5F-AFFFD54529D3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2B22-407D-9A5F-AFFFD54529D3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B22-407D-9A5F-AFFFD54529D3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B22-407D-9A5F-AFFFD54529D3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B22-407D-9A5F-AFFFD54529D3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B22-407D-9A5F-AFFFD54529D3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C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B22-407D-9A5F-AFFFD54529D3}"/>
                </c:ext>
              </c:extLst>
            </c:dLbl>
            <c:dLbl>
              <c:idx val="2"/>
              <c:layout>
                <c:manualLayout>
                  <c:x val="0"/>
                  <c:y val="-6.704779411764705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B22-407D-9A5F-AFFFD54529D3}"/>
                </c:ext>
              </c:extLst>
            </c:dLbl>
            <c:dLbl>
              <c:idx val="3"/>
              <c:layout>
                <c:manualLayout>
                  <c:x val="0"/>
                  <c:y val="-3.112745098039215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2B22-407D-9A5F-AFFFD54529D3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2B22-407D-9A5F-AFFFD54529D3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2B22-407D-9A5F-AFFFD54529D3}"/>
                </c:ext>
              </c:extLst>
            </c:dLbl>
            <c:dLbl>
              <c:idx val="6"/>
              <c:layout>
                <c:manualLayout>
                  <c:x val="0"/>
                  <c:y val="-2.075163398692810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2B22-407D-9A5F-AFFFD54529D3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2B22-407D-9A5F-AFFFD54529D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R'!$AU$3:$AU$10</c:f>
                <c:numCache>
                  <c:formatCode>General</c:formatCode>
                  <c:ptCount val="8"/>
                  <c:pt idx="0">
                    <c:v>229442.18217431055</c:v>
                  </c:pt>
                  <c:pt idx="1">
                    <c:v>71129.792045042457</c:v>
                  </c:pt>
                  <c:pt idx="2">
                    <c:v>2673482.2758017695</c:v>
                  </c:pt>
                  <c:pt idx="3">
                    <c:v>1061545.6080302005</c:v>
                  </c:pt>
                  <c:pt idx="4">
                    <c:v>758875.04260099807</c:v>
                  </c:pt>
                  <c:pt idx="5">
                    <c:v>365731.10678809194</c:v>
                  </c:pt>
                  <c:pt idx="6">
                    <c:v>950930.63926878804</c:v>
                  </c:pt>
                  <c:pt idx="7">
                    <c:v>663316.74869532697</c:v>
                  </c:pt>
                </c:numCache>
              </c:numRef>
            </c:plus>
            <c:minus>
              <c:numRef>
                <c:f>'Bacterias R'!$AU$3:$AU$10</c:f>
                <c:numCache>
                  <c:formatCode>General</c:formatCode>
                  <c:ptCount val="8"/>
                  <c:pt idx="0">
                    <c:v>229442.18217431055</c:v>
                  </c:pt>
                  <c:pt idx="1">
                    <c:v>71129.792045042457</c:v>
                  </c:pt>
                  <c:pt idx="2">
                    <c:v>2673482.2758017695</c:v>
                  </c:pt>
                  <c:pt idx="3">
                    <c:v>1061545.6080302005</c:v>
                  </c:pt>
                  <c:pt idx="4">
                    <c:v>758875.04260099807</c:v>
                  </c:pt>
                  <c:pt idx="5">
                    <c:v>365731.10678809194</c:v>
                  </c:pt>
                  <c:pt idx="6">
                    <c:v>950930.63926878804</c:v>
                  </c:pt>
                  <c:pt idx="7">
                    <c:v>663316.748695326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R'!$AQ$3:$AS$10</c:f>
              <c:multiLvlStrCache>
                <c:ptCount val="8"/>
                <c:lvl>
                  <c:pt idx="0">
                    <c:v>Control</c:v>
                  </c:pt>
                  <c:pt idx="1">
                    <c:v>BNI</c:v>
                  </c:pt>
                  <c:pt idx="2">
                    <c:v>Control</c:v>
                  </c:pt>
                  <c:pt idx="3">
                    <c:v>BNI</c:v>
                  </c:pt>
                  <c:pt idx="4">
                    <c:v>Control</c:v>
                  </c:pt>
                  <c:pt idx="5">
                    <c:v>BNI</c:v>
                  </c:pt>
                  <c:pt idx="6">
                    <c:v>Control</c:v>
                  </c:pt>
                  <c:pt idx="7">
                    <c:v>BNI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R'!$AT$3:$AT$10</c:f>
              <c:numCache>
                <c:formatCode>0.00E+00</c:formatCode>
                <c:ptCount val="8"/>
                <c:pt idx="0">
                  <c:v>2522051.0661582053</c:v>
                </c:pt>
                <c:pt idx="1">
                  <c:v>1760440.049912143</c:v>
                </c:pt>
                <c:pt idx="2">
                  <c:v>12902308.426726468</c:v>
                </c:pt>
                <c:pt idx="3">
                  <c:v>9315725.5400681403</c:v>
                </c:pt>
                <c:pt idx="4">
                  <c:v>6282714.1936680768</c:v>
                </c:pt>
                <c:pt idx="5">
                  <c:v>5503251.5935750026</c:v>
                </c:pt>
                <c:pt idx="6">
                  <c:v>8673370.2328120302</c:v>
                </c:pt>
                <c:pt idx="7">
                  <c:v>9143917.58739909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B22-407D-9A5F-AFFFD54529D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87937712"/>
        <c:axId val="487947224"/>
      </c:barChart>
      <c:catAx>
        <c:axId val="487937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87947224"/>
        <c:crosses val="autoZero"/>
        <c:auto val="1"/>
        <c:lblAlgn val="ctr"/>
        <c:lblOffset val="100"/>
        <c:noMultiLvlLbl val="0"/>
      </c:catAx>
      <c:valAx>
        <c:axId val="487947224"/>
        <c:scaling>
          <c:orientation val="minMax"/>
          <c:max val="2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87937712"/>
        <c:crosses val="autoZero"/>
        <c:crossBetween val="between"/>
        <c:majorUnit val="4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94B-436D-B370-61B21FF76F2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94B-436D-B370-61B21FF76F2F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94B-436D-B370-61B21FF76F2F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94B-436D-B370-61B21FF76F2F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94B-436D-B370-61B21FF76F2F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994B-436D-B370-61B21FF76F2F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94B-436D-B370-61B21FF76F2F}"/>
              </c:ext>
            </c:extLst>
          </c:dPt>
          <c:dLbls>
            <c:dLbl>
              <c:idx val="0"/>
              <c:layout>
                <c:manualLayout>
                  <c:x val="-3.8044222819259745E-17"/>
                  <c:y val="-1.924242424242424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94B-436D-B370-61B21FF76F2F}"/>
                </c:ext>
              </c:extLst>
            </c:dLbl>
            <c:dLbl>
              <c:idx val="1"/>
              <c:layout>
                <c:manualLayout>
                  <c:x val="-7.6088445638519489E-17"/>
                  <c:y val="-1.924242424242424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94B-436D-B370-61B21FF76F2F}"/>
                </c:ext>
              </c:extLst>
            </c:dLbl>
            <c:dLbl>
              <c:idx val="2"/>
              <c:layout>
                <c:manualLayout>
                  <c:x val="-7.6088445638519489E-17"/>
                  <c:y val="-5.343434343434349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994B-436D-B370-61B21FF76F2F}"/>
                </c:ext>
              </c:extLst>
            </c:dLbl>
            <c:dLbl>
              <c:idx val="3"/>
              <c:layout>
                <c:manualLayout>
                  <c:x val="0"/>
                  <c:y val="-5.772727272727275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994B-436D-B370-61B21FF76F2F}"/>
                </c:ext>
              </c:extLst>
            </c:dLbl>
            <c:dLbl>
              <c:idx val="4"/>
              <c:layout>
                <c:manualLayout>
                  <c:x val="0"/>
                  <c:y val="-2.314814814814814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994B-436D-B370-61B21FF76F2F}"/>
                </c:ext>
              </c:extLst>
            </c:dLbl>
            <c:dLbl>
              <c:idx val="5"/>
              <c:layout>
                <c:manualLayout>
                  <c:x val="-4.1503267973856213E-3"/>
                  <c:y val="-3.207070707070706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994B-436D-B370-61B21FF76F2F}"/>
                </c:ext>
              </c:extLst>
            </c:dLbl>
            <c:dLbl>
              <c:idx val="6"/>
              <c:layout>
                <c:manualLayout>
                  <c:x val="4.1503267973856213E-3"/>
                  <c:y val="-4.489898989898989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994B-436D-B370-61B21FF76F2F}"/>
                </c:ext>
              </c:extLst>
            </c:dLbl>
            <c:dLbl>
              <c:idx val="7"/>
              <c:layout>
                <c:manualLayout>
                  <c:x val="0"/>
                  <c:y val="-4.417525252525258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994B-436D-B370-61B21FF76F2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R'!$AC$3:$AC$10</c:f>
                <c:numCache>
                  <c:formatCode>General</c:formatCode>
                  <c:ptCount val="8"/>
                  <c:pt idx="0">
                    <c:v>1479738.7855324824</c:v>
                  </c:pt>
                  <c:pt idx="1">
                    <c:v>487054.13420241297</c:v>
                  </c:pt>
                  <c:pt idx="2">
                    <c:v>5470455.2317824373</c:v>
                  </c:pt>
                  <c:pt idx="3">
                    <c:v>4880538.3619897747</c:v>
                  </c:pt>
                  <c:pt idx="4">
                    <c:v>2297973.7253453494</c:v>
                  </c:pt>
                  <c:pt idx="5">
                    <c:v>4094022.9356908631</c:v>
                  </c:pt>
                  <c:pt idx="6">
                    <c:v>4764585.7355736345</c:v>
                  </c:pt>
                  <c:pt idx="7">
                    <c:v>3508920.9827578762</c:v>
                  </c:pt>
                </c:numCache>
              </c:numRef>
            </c:plus>
            <c:minus>
              <c:numRef>
                <c:f>'Bacterias R'!$AC$3:$AC$10</c:f>
                <c:numCache>
                  <c:formatCode>General</c:formatCode>
                  <c:ptCount val="8"/>
                  <c:pt idx="0">
                    <c:v>1479738.7855324824</c:v>
                  </c:pt>
                  <c:pt idx="1">
                    <c:v>487054.13420241297</c:v>
                  </c:pt>
                  <c:pt idx="2">
                    <c:v>5470455.2317824373</c:v>
                  </c:pt>
                  <c:pt idx="3">
                    <c:v>4880538.3619897747</c:v>
                  </c:pt>
                  <c:pt idx="4">
                    <c:v>2297973.7253453494</c:v>
                  </c:pt>
                  <c:pt idx="5">
                    <c:v>4094022.9356908631</c:v>
                  </c:pt>
                  <c:pt idx="6">
                    <c:v>4764585.7355736345</c:v>
                  </c:pt>
                  <c:pt idx="7">
                    <c:v>3508920.98275787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R'!$Y$3:$AA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R'!$AB$3:$AB$10</c:f>
              <c:numCache>
                <c:formatCode>0.00E+00</c:formatCode>
                <c:ptCount val="8"/>
                <c:pt idx="0">
                  <c:v>12715080.862292485</c:v>
                </c:pt>
                <c:pt idx="1">
                  <c:v>10006891.484661277</c:v>
                </c:pt>
                <c:pt idx="2">
                  <c:v>28100139.899088476</c:v>
                </c:pt>
                <c:pt idx="3">
                  <c:v>34831795.94668667</c:v>
                </c:pt>
                <c:pt idx="4">
                  <c:v>34663529.899321213</c:v>
                </c:pt>
                <c:pt idx="5">
                  <c:v>42997242.329288334</c:v>
                </c:pt>
                <c:pt idx="6">
                  <c:v>29808091.828674372</c:v>
                </c:pt>
                <c:pt idx="7">
                  <c:v>30391778.336698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994B-436D-B370-61B21FF76F2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516295480"/>
        <c:axId val="516296464"/>
      </c:barChart>
      <c:catAx>
        <c:axId val="5162954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16296464"/>
        <c:crosses val="autoZero"/>
        <c:auto val="1"/>
        <c:lblAlgn val="ctr"/>
        <c:lblOffset val="100"/>
        <c:noMultiLvlLbl val="0"/>
      </c:catAx>
      <c:valAx>
        <c:axId val="516296464"/>
        <c:scaling>
          <c:orientation val="minMax"/>
          <c:max val="6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516295480"/>
        <c:crosses val="autoZero"/>
        <c:crossBetween val="between"/>
        <c:majorUnit val="20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9E2-4C45-9970-D8A436A05C5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9E2-4C45-9970-D8A436A05C52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9E2-4C45-9970-D8A436A05C52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E9E2-4C45-9970-D8A436A05C52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9E2-4C45-9970-D8A436A05C52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9E2-4C45-9970-D8A436A05C52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9E2-4C45-9970-D8A436A05C52}"/>
              </c:ext>
            </c:extLst>
          </c:dPt>
          <c:dLbls>
            <c:dLbl>
              <c:idx val="0"/>
              <c:layout>
                <c:manualLayout>
                  <c:x val="4.1503267973856213E-3"/>
                  <c:y val="-2.565656565656565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9E2-4C45-9970-D8A436A05C52}"/>
                </c:ext>
              </c:extLst>
            </c:dLbl>
            <c:dLbl>
              <c:idx val="1"/>
              <c:layout>
                <c:manualLayout>
                  <c:x val="-3.8044222819259745E-17"/>
                  <c:y val="-1.924242424242424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9E2-4C45-9970-D8A436A05C52}"/>
                </c:ext>
              </c:extLst>
            </c:dLbl>
            <c:dLbl>
              <c:idx val="2"/>
              <c:layout>
                <c:manualLayout>
                  <c:x val="4.1503267973855449E-3"/>
                  <c:y val="-4.417525252525252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E9E2-4C45-9970-D8A436A05C52}"/>
                </c:ext>
              </c:extLst>
            </c:dLbl>
            <c:dLbl>
              <c:idx val="3"/>
              <c:layout>
                <c:manualLayout>
                  <c:x val="0"/>
                  <c:y val="-4.417525252525252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E9E2-4C45-9970-D8A436A05C52}"/>
                </c:ext>
              </c:extLst>
            </c:dLbl>
            <c:dLbl>
              <c:idx val="4"/>
              <c:layout>
                <c:manualLayout>
                  <c:x val="-7.6088445638519489E-17"/>
                  <c:y val="-5.343434343434346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E9E2-4C45-9970-D8A436A05C52}"/>
                </c:ext>
              </c:extLst>
            </c:dLbl>
            <c:dLbl>
              <c:idx val="5"/>
              <c:layout>
                <c:manualLayout>
                  <c:x val="-8.3006535947712425E-3"/>
                  <c:y val="-4.880454545454545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E9E2-4C45-9970-D8A436A05C52}"/>
                </c:ext>
              </c:extLst>
            </c:dLbl>
            <c:dLbl>
              <c:idx val="6"/>
              <c:layout>
                <c:manualLayout>
                  <c:x val="-4.1503267973856213E-3"/>
                  <c:y val="-6.341767676767676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E9E2-4C45-9970-D8A436A05C52}"/>
                </c:ext>
              </c:extLst>
            </c:dLbl>
            <c:dLbl>
              <c:idx val="7"/>
              <c:layout>
                <c:manualLayout>
                  <c:x val="0"/>
                  <c:y val="-3.1346969696969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E9E2-4C45-9970-D8A436A05C5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R'!$AI$3:$AI$10</c:f>
                <c:numCache>
                  <c:formatCode>General</c:formatCode>
                  <c:ptCount val="8"/>
                  <c:pt idx="0">
                    <c:v>723798.33258714562</c:v>
                  </c:pt>
                  <c:pt idx="1">
                    <c:v>249793.21206581133</c:v>
                  </c:pt>
                  <c:pt idx="2">
                    <c:v>1673469.9557312077</c:v>
                  </c:pt>
                  <c:pt idx="3">
                    <c:v>1887148.1653789524</c:v>
                  </c:pt>
                  <c:pt idx="4">
                    <c:v>1866821.8621621514</c:v>
                  </c:pt>
                  <c:pt idx="5">
                    <c:v>1839706.4105935548</c:v>
                  </c:pt>
                  <c:pt idx="6">
                    <c:v>1838779.6920262317</c:v>
                  </c:pt>
                  <c:pt idx="7">
                    <c:v>1718335.4720288361</c:v>
                  </c:pt>
                </c:numCache>
              </c:numRef>
            </c:plus>
            <c:minus>
              <c:numRef>
                <c:f>'Bacterias R'!$AI$3:$AI$10</c:f>
                <c:numCache>
                  <c:formatCode>General</c:formatCode>
                  <c:ptCount val="8"/>
                  <c:pt idx="0">
                    <c:v>723798.33258714562</c:v>
                  </c:pt>
                  <c:pt idx="1">
                    <c:v>249793.21206581133</c:v>
                  </c:pt>
                  <c:pt idx="2">
                    <c:v>1673469.9557312077</c:v>
                  </c:pt>
                  <c:pt idx="3">
                    <c:v>1887148.1653789524</c:v>
                  </c:pt>
                  <c:pt idx="4">
                    <c:v>1866821.8621621514</c:v>
                  </c:pt>
                  <c:pt idx="5">
                    <c:v>1839706.4105935548</c:v>
                  </c:pt>
                  <c:pt idx="6">
                    <c:v>1838779.6920262317</c:v>
                  </c:pt>
                  <c:pt idx="7">
                    <c:v>1718335.47202883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R'!$AE$3:$AG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R'!$AH$3:$AH$10</c:f>
              <c:numCache>
                <c:formatCode>0.00E+00</c:formatCode>
                <c:ptCount val="8"/>
                <c:pt idx="0">
                  <c:v>6784023.0509359054</c:v>
                </c:pt>
                <c:pt idx="1">
                  <c:v>4798327.9442505948</c:v>
                </c:pt>
                <c:pt idx="2">
                  <c:v>11090579.357365994</c:v>
                </c:pt>
                <c:pt idx="3">
                  <c:v>11408684.464369668</c:v>
                </c:pt>
                <c:pt idx="4">
                  <c:v>17421226.003682446</c:v>
                </c:pt>
                <c:pt idx="5">
                  <c:v>14939556.444215633</c:v>
                </c:pt>
                <c:pt idx="6">
                  <c:v>12112211.354605768</c:v>
                </c:pt>
                <c:pt idx="7">
                  <c:v>15716246.1977419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E9E2-4C45-9970-D8A436A05C5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516287608"/>
        <c:axId val="516286624"/>
      </c:barChart>
      <c:catAx>
        <c:axId val="5162876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16286624"/>
        <c:crosses val="autoZero"/>
        <c:auto val="1"/>
        <c:lblAlgn val="ctr"/>
        <c:lblOffset val="100"/>
        <c:noMultiLvlLbl val="0"/>
      </c:catAx>
      <c:valAx>
        <c:axId val="516286624"/>
        <c:scaling>
          <c:orientation val="minMax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51628760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3C3-43C1-9896-587F66B6EB8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3C3-43C1-9896-587F66B6EB84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rgbClr val="99336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3C3-43C1-9896-587F66B6EB84}"/>
              </c:ext>
            </c:extLst>
          </c:dPt>
          <c:dPt>
            <c:idx val="3"/>
            <c:invertIfNegative val="0"/>
            <c:bubble3D val="0"/>
            <c:spPr>
              <a:solidFill>
                <a:srgbClr val="9933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D3C3-43C1-9896-587F66B6EB84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accent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3C3-43C1-9896-587F66B6EB8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3C3-43C1-9896-587F66B6EB84}"/>
              </c:ext>
            </c:extLst>
          </c:dPt>
          <c:dPt>
            <c:idx val="6"/>
            <c:invertIfNegative val="0"/>
            <c:bubble3D val="0"/>
            <c:spPr>
              <a:pattFill prst="lt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3C3-43C1-9896-587F66B6EB8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D3C3-43C1-9896-587F66B6EB8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C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D3C3-43C1-9896-587F66B6EB84}"/>
                </c:ext>
              </c:extLst>
            </c:dLbl>
            <c:dLbl>
              <c:idx val="2"/>
              <c:layout>
                <c:manualLayout>
                  <c:x val="-7.6088445638519489E-17"/>
                  <c:y val="-4.702020202020201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D3C3-43C1-9896-587F66B6EB84}"/>
                </c:ext>
              </c:extLst>
            </c:dLbl>
            <c:dLbl>
              <c:idx val="3"/>
              <c:layout>
                <c:manualLayout>
                  <c:x val="0"/>
                  <c:y val="-1.9242424242424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D3C3-43C1-9896-587F66B6EB84}"/>
                </c:ext>
              </c:extLst>
            </c:dLbl>
            <c:dLbl>
              <c:idx val="4"/>
              <c:layout>
                <c:manualLayout>
                  <c:x val="-4.1503267973855449E-3"/>
                  <c:y val="-3.207070707070713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D3C3-43C1-9896-587F66B6EB84}"/>
                </c:ext>
              </c:extLst>
            </c:dLbl>
            <c:dLbl>
              <c:idx val="5"/>
              <c:layout>
                <c:manualLayout>
                  <c:x val="0"/>
                  <c:y val="-4.417525252525252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D3C3-43C1-9896-587F66B6EB84}"/>
                </c:ext>
              </c:extLst>
            </c:dLbl>
            <c:dLbl>
              <c:idx val="6"/>
              <c:layout>
                <c:manualLayout>
                  <c:x val="-4.1503267973856213E-3"/>
                  <c:y val="-3.848484848484848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D3C3-43C1-9896-587F66B6EB84}"/>
                </c:ext>
              </c:extLst>
            </c:dLbl>
            <c:dLbl>
              <c:idx val="7"/>
              <c:layout>
                <c:manualLayout>
                  <c:x val="-4.1503267973856213E-3"/>
                  <c:y val="-1.924242424242427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D3C3-43C1-9896-587F66B6EB8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cterias R'!$AO$3:$AO$10</c:f>
                <c:numCache>
                  <c:formatCode>General</c:formatCode>
                  <c:ptCount val="8"/>
                  <c:pt idx="0">
                    <c:v>615031.53461556812</c:v>
                  </c:pt>
                  <c:pt idx="1">
                    <c:v>437797.29655940685</c:v>
                  </c:pt>
                  <c:pt idx="2">
                    <c:v>2535709.1168047427</c:v>
                  </c:pt>
                  <c:pt idx="3">
                    <c:v>804373.98676720134</c:v>
                  </c:pt>
                  <c:pt idx="4">
                    <c:v>1882090.0755487541</c:v>
                  </c:pt>
                  <c:pt idx="5">
                    <c:v>1786408.2522382727</c:v>
                  </c:pt>
                  <c:pt idx="6">
                    <c:v>1957498.8608537926</c:v>
                  </c:pt>
                  <c:pt idx="7">
                    <c:v>2703630.2889430751</c:v>
                  </c:pt>
                </c:numCache>
              </c:numRef>
            </c:plus>
            <c:minus>
              <c:numRef>
                <c:f>'Bacterias R'!$AO$3:$AO$10</c:f>
                <c:numCache>
                  <c:formatCode>General</c:formatCode>
                  <c:ptCount val="8"/>
                  <c:pt idx="0">
                    <c:v>615031.53461556812</c:v>
                  </c:pt>
                  <c:pt idx="1">
                    <c:v>437797.29655940685</c:v>
                  </c:pt>
                  <c:pt idx="2">
                    <c:v>2535709.1168047427</c:v>
                  </c:pt>
                  <c:pt idx="3">
                    <c:v>804373.98676720134</c:v>
                  </c:pt>
                  <c:pt idx="4">
                    <c:v>1882090.0755487541</c:v>
                  </c:pt>
                  <c:pt idx="5">
                    <c:v>1786408.2522382727</c:v>
                  </c:pt>
                  <c:pt idx="6">
                    <c:v>1957498.8608537926</c:v>
                  </c:pt>
                  <c:pt idx="7">
                    <c:v>2703630.28894307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Bacterias R'!$AK$3:$AM$10</c:f>
              <c:multiLvlStrCache>
                <c:ptCount val="8"/>
                <c:lvl>
                  <c:pt idx="0">
                    <c:v>BNI-</c:v>
                  </c:pt>
                  <c:pt idx="1">
                    <c:v>BNI+</c:v>
                  </c:pt>
                  <c:pt idx="2">
                    <c:v>BNI-</c:v>
                  </c:pt>
                  <c:pt idx="3">
                    <c:v>BNI+</c:v>
                  </c:pt>
                  <c:pt idx="4">
                    <c:v>BNI-</c:v>
                  </c:pt>
                  <c:pt idx="5">
                    <c:v>BNI+</c:v>
                  </c:pt>
                  <c:pt idx="6">
                    <c:v>BNI-</c:v>
                  </c:pt>
                  <c:pt idx="7">
                    <c:v>BNI+</c:v>
                  </c:pt>
                </c:lvl>
                <c:lvl>
                  <c:pt idx="2">
                    <c:v>NK</c:v>
                  </c:pt>
                  <c:pt idx="4">
                    <c:v>A</c:v>
                  </c:pt>
                  <c:pt idx="6">
                    <c:v>A+D</c:v>
                  </c:pt>
                </c:lvl>
                <c:lvl>
                  <c:pt idx="0">
                    <c:v>T0</c:v>
                  </c:pt>
                  <c:pt idx="2">
                    <c:v>T30</c:v>
                  </c:pt>
                </c:lvl>
              </c:multiLvlStrCache>
            </c:multiLvlStrRef>
          </c:cat>
          <c:val>
            <c:numRef>
              <c:f>'Bacterias R'!$AN$3:$AN$10</c:f>
              <c:numCache>
                <c:formatCode>0.00E+00</c:formatCode>
                <c:ptCount val="8"/>
                <c:pt idx="0">
                  <c:v>6187239.1022455916</c:v>
                </c:pt>
                <c:pt idx="1">
                  <c:v>5498970.9177932227</c:v>
                </c:pt>
                <c:pt idx="2">
                  <c:v>22657713.723603159</c:v>
                </c:pt>
                <c:pt idx="3">
                  <c:v>23849490.425737277</c:v>
                </c:pt>
                <c:pt idx="4">
                  <c:v>15268168.897203596</c:v>
                </c:pt>
                <c:pt idx="5">
                  <c:v>13662843.241982587</c:v>
                </c:pt>
                <c:pt idx="6">
                  <c:v>22134748.096756484</c:v>
                </c:pt>
                <c:pt idx="7">
                  <c:v>26881988.2747240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D3C3-43C1-9896-587F66B6EB8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-27"/>
        <c:axId val="487927216"/>
        <c:axId val="487932792"/>
      </c:barChart>
      <c:catAx>
        <c:axId val="4879272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87932792"/>
        <c:crosses val="autoZero"/>
        <c:auto val="1"/>
        <c:lblAlgn val="ctr"/>
        <c:lblOffset val="100"/>
        <c:noMultiLvlLbl val="0"/>
      </c:catAx>
      <c:valAx>
        <c:axId val="487932792"/>
        <c:scaling>
          <c:orientation val="minMax"/>
          <c:max val="4000000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87927216"/>
        <c:crosses val="autoZero"/>
        <c:crossBetween val="between"/>
        <c:majorUnit val="10000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0295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28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5205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476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4500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6603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58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3881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9947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02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2975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34627F-AF59-4AE4-B70E-3AD1905928B0}" type="datetimeFigureOut">
              <a:rPr lang="es-ES" smtClean="0"/>
              <a:t>10/10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C3263-65BB-4BDB-B2A9-3B1BABAA84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5546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1.xml"/><Relationship Id="rId3" Type="http://schemas.openxmlformats.org/officeDocument/2006/relationships/chart" Target="../charts/chart6.xml"/><Relationship Id="rId7" Type="http://schemas.openxmlformats.org/officeDocument/2006/relationships/chart" Target="../charts/chart10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9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Relationship Id="rId9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ángulo 2">
            <a:extLst>
              <a:ext uri="{FF2B5EF4-FFF2-40B4-BE49-F238E27FC236}">
                <a16:creationId xmlns:a16="http://schemas.microsoft.com/office/drawing/2014/main" id="{D4F12ACE-CBE0-4840-AA12-0727F474B5F1}"/>
              </a:ext>
            </a:extLst>
          </p:cNvPr>
          <p:cNvSpPr/>
          <p:nvPr/>
        </p:nvSpPr>
        <p:spPr>
          <a:xfrm>
            <a:off x="40191" y="1621923"/>
            <a:ext cx="3429000" cy="86177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 pH (1:2.5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il:water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  <a:p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 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jeldahl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gestion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eney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elson, 1982). 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 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ganic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ter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lkley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lack, 1934). </a:t>
            </a:r>
            <a:endParaRPr lang="es-E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 CaCO3 , Mg, K (NH4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O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PA, 1994). </a:t>
            </a:r>
          </a:p>
          <a:p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 P (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tanabe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sen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965). </a:t>
            </a:r>
            <a:endParaRPr lang="es-ES" sz="10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ángulo 3"/>
          <p:cNvSpPr/>
          <p:nvPr/>
        </p:nvSpPr>
        <p:spPr>
          <a:xfrm>
            <a:off x="40191" y="114431"/>
            <a:ext cx="6817809" cy="5863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ysical and chemical properties of the soil collected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 – 30 cm depth layer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Experimental Station Norman Borlaug CENEB at the Yaqui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ley (Sonora, Mexico) and in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kaute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lava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pain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soil of microcosm experiment was mixed with sand in </a:t>
            </a:r>
            <a:r>
              <a:rPr lang="en-GB" sz="10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il:sand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:1 proportion</a:t>
            </a:r>
            <a:endParaRPr lang="es-ES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C1AE77EE-E40F-874D-9EB3-25D7AB0439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3329168"/>
              </p:ext>
            </p:extLst>
          </p:nvPr>
        </p:nvGraphicFramePr>
        <p:xfrm>
          <a:off x="97341" y="684773"/>
          <a:ext cx="6642428" cy="937150"/>
        </p:xfrm>
        <a:graphic>
          <a:graphicData uri="http://schemas.openxmlformats.org/drawingml/2006/table">
            <a:tbl>
              <a:tblPr/>
              <a:tblGrid>
                <a:gridCol w="1276457">
                  <a:extLst>
                    <a:ext uri="{9D8B030D-6E8A-4147-A177-3AD203B41FA5}">
                      <a16:colId xmlns:a16="http://schemas.microsoft.com/office/drawing/2014/main" val="3248038725"/>
                    </a:ext>
                  </a:extLst>
                </a:gridCol>
                <a:gridCol w="186989">
                  <a:extLst>
                    <a:ext uri="{9D8B030D-6E8A-4147-A177-3AD203B41FA5}">
                      <a16:colId xmlns:a16="http://schemas.microsoft.com/office/drawing/2014/main" val="528002946"/>
                    </a:ext>
                  </a:extLst>
                </a:gridCol>
                <a:gridCol w="420409">
                  <a:extLst>
                    <a:ext uri="{9D8B030D-6E8A-4147-A177-3AD203B41FA5}">
                      <a16:colId xmlns:a16="http://schemas.microsoft.com/office/drawing/2014/main" val="3523109441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3263086965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3880250638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3437263105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1301282374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446909206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725396350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343396523"/>
                    </a:ext>
                  </a:extLst>
                </a:gridCol>
                <a:gridCol w="456341">
                  <a:extLst>
                    <a:ext uri="{9D8B030D-6E8A-4147-A177-3AD203B41FA5}">
                      <a16:colId xmlns:a16="http://schemas.microsoft.com/office/drawing/2014/main" val="2713547695"/>
                    </a:ext>
                  </a:extLst>
                </a:gridCol>
                <a:gridCol w="657844">
                  <a:extLst>
                    <a:ext uri="{9D8B030D-6E8A-4147-A177-3AD203B41FA5}">
                      <a16:colId xmlns:a16="http://schemas.microsoft.com/office/drawing/2014/main" val="3046362314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1874691798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37571137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1615759628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3737414699"/>
                    </a:ext>
                  </a:extLst>
                </a:gridCol>
                <a:gridCol w="303699">
                  <a:extLst>
                    <a:ext uri="{9D8B030D-6E8A-4147-A177-3AD203B41FA5}">
                      <a16:colId xmlns:a16="http://schemas.microsoft.com/office/drawing/2014/main" val="3922576330"/>
                    </a:ext>
                  </a:extLst>
                </a:gridCol>
              </a:tblGrid>
              <a:tr h="103134">
                <a:tc>
                  <a:txBody>
                    <a:bodyPr/>
                    <a:lstStyle/>
                    <a:p>
                      <a:pPr algn="l" rtl="0" fontAlgn="b"/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</a:t>
                      </a:r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xture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l" fontAlgn="b"/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1"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</a:t>
                      </a:r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ical</a:t>
                      </a:r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erties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3841322"/>
                  </a:ext>
                </a:extLst>
              </a:tr>
              <a:tr h="194134">
                <a:tc>
                  <a:txBody>
                    <a:bodyPr/>
                    <a:lstStyle/>
                    <a:p>
                      <a:pPr algn="l" rtl="0" fontAlgn="b"/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d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lt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y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</a:t>
                      </a:r>
                      <a:r>
                        <a:rPr lang="es-ES" sz="10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:N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b"/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s-E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ic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 rtl="0" fontAlgn="b"/>
                      <a:r>
                        <a:rPr lang="es-ES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ter</a:t>
                      </a:r>
                      <a:r>
                        <a:rPr lang="es-ES" sz="10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onate</a:t>
                      </a:r>
                      <a:r>
                        <a:rPr lang="es-ES" sz="10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b"/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s-E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</a:t>
                      </a:r>
                      <a:r>
                        <a:rPr lang="es-ES" sz="10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s-ES" sz="10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</a:t>
                      </a:r>
                      <a:r>
                        <a:rPr lang="es-ES" sz="10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7794778"/>
                  </a:ext>
                </a:extLst>
              </a:tr>
              <a:tr h="97067">
                <a:tc>
                  <a:txBody>
                    <a:bodyPr/>
                    <a:lstStyle/>
                    <a:p>
                      <a:pPr algn="ctr" rtl="0" fontAlgn="b"/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 kg</a:t>
                      </a:r>
                      <a:r>
                        <a:rPr lang="es-E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b"/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g kg</a:t>
                      </a:r>
                      <a:r>
                        <a:rPr lang="es-E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s-E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8924875"/>
                  </a:ext>
                </a:extLst>
              </a:tr>
              <a:tr h="97067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eld </a:t>
                      </a:r>
                      <a:r>
                        <a:rPr lang="es-E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riment</a:t>
                      </a:r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1</a:t>
                      </a:r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7</a:t>
                      </a:r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2</a:t>
                      </a:r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2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3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4766805"/>
                  </a:ext>
                </a:extLst>
              </a:tr>
              <a:tr h="97067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cosm</a:t>
                      </a:r>
                      <a:r>
                        <a:rPr lang="es-E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riment</a:t>
                      </a:r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4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7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9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5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6</a:t>
                      </a:r>
                      <a:endParaRPr lang="es-E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50" marR="4550" marT="45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03608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9609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2599842"/>
              </p:ext>
            </p:extLst>
          </p:nvPr>
        </p:nvGraphicFramePr>
        <p:xfrm>
          <a:off x="3665844" y="2054727"/>
          <a:ext cx="2772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áfico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5430084"/>
              </p:ext>
            </p:extLst>
          </p:nvPr>
        </p:nvGraphicFramePr>
        <p:xfrm>
          <a:off x="564504" y="2054347"/>
          <a:ext cx="2772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á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1624867"/>
              </p:ext>
            </p:extLst>
          </p:nvPr>
        </p:nvGraphicFramePr>
        <p:xfrm>
          <a:off x="564504" y="362707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9471470"/>
              </p:ext>
            </p:extLst>
          </p:nvPr>
        </p:nvGraphicFramePr>
        <p:xfrm>
          <a:off x="3667606" y="365637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CuadroTexto 5"/>
          <p:cNvSpPr txBox="1"/>
          <p:nvPr/>
        </p:nvSpPr>
        <p:spPr>
          <a:xfrm rot="16200000">
            <a:off x="2865627" y="972652"/>
            <a:ext cx="12907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bacteria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uadroTexto 6"/>
          <p:cNvSpPr txBox="1"/>
          <p:nvPr/>
        </p:nvSpPr>
        <p:spPr>
          <a:xfrm rot="16200000">
            <a:off x="-211618" y="972652"/>
            <a:ext cx="12907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bacteria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uadroTexto 7"/>
          <p:cNvSpPr txBox="1"/>
          <p:nvPr/>
        </p:nvSpPr>
        <p:spPr>
          <a:xfrm rot="16200000">
            <a:off x="-191709" y="2682555"/>
            <a:ext cx="12763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chaea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1828969" y="115108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ELFS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4977493" y="115108"/>
            <a:ext cx="6703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NAL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 rot="16200000">
            <a:off x="2863900" y="2676325"/>
            <a:ext cx="12763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chaea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1180612" y="50431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4277381" y="50431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1176756" y="220193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CuadroTexto 14"/>
          <p:cNvSpPr txBox="1"/>
          <p:nvPr/>
        </p:nvSpPr>
        <p:spPr>
          <a:xfrm>
            <a:off x="4277381" y="220223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ángulo 15"/>
          <p:cNvSpPr/>
          <p:nvPr/>
        </p:nvSpPr>
        <p:spPr>
          <a:xfrm>
            <a:off x="241160" y="4534135"/>
            <a:ext cx="6126468" cy="12338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</a:t>
            </a: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1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bundance of soil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tal bacteria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archaea 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ROELFS (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and </a:t>
            </a: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NAL 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BNI-isogenic-lines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cking BNI-trait (Control) and with BNI-trait (BNI). Wheat was fertilized with potassium nitrate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N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monium sulphate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mmonium sulphate + DMPP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+D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 differences between N treatments of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-isogenic-lines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 marked with a lowercase letter. Significant differences between N treatments of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NI-isogenic-lines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 marked with a capital letter. The Mann-Whitney U test was used for the comparison between the absence or the presence of BNI-trait within the same fertilization treatment and the significant differences at p &lt;0.05 are marked with an asterisk (*).</a:t>
            </a:r>
            <a:endParaRPr lang="es-E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7" name="Grupo 16"/>
          <p:cNvGrpSpPr/>
          <p:nvPr/>
        </p:nvGrpSpPr>
        <p:grpSpPr>
          <a:xfrm>
            <a:off x="1755531" y="4044854"/>
            <a:ext cx="405301" cy="246221"/>
            <a:chOff x="1986457" y="6135127"/>
            <a:chExt cx="405301" cy="246221"/>
          </a:xfrm>
        </p:grpSpPr>
        <p:sp>
          <p:nvSpPr>
            <p:cNvPr id="18" name="Rectángulo 17"/>
            <p:cNvSpPr/>
            <p:nvPr/>
          </p:nvSpPr>
          <p:spPr>
            <a:xfrm>
              <a:off x="1986457" y="6157026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1990323" y="6135127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N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" name="Grupo 19"/>
          <p:cNvGrpSpPr/>
          <p:nvPr/>
        </p:nvGrpSpPr>
        <p:grpSpPr>
          <a:xfrm>
            <a:off x="2257438" y="4059133"/>
            <a:ext cx="405301" cy="246221"/>
            <a:chOff x="2472013" y="6141223"/>
            <a:chExt cx="405301" cy="246221"/>
          </a:xfrm>
        </p:grpSpPr>
        <p:sp>
          <p:nvSpPr>
            <p:cNvPr id="21" name="Rectángulo 20"/>
            <p:cNvSpPr/>
            <p:nvPr/>
          </p:nvSpPr>
          <p:spPr>
            <a:xfrm>
              <a:off x="2472013" y="6157025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2490195" y="6141223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Grupo 22"/>
          <p:cNvGrpSpPr/>
          <p:nvPr/>
        </p:nvGrpSpPr>
        <p:grpSpPr>
          <a:xfrm>
            <a:off x="2698270" y="4061620"/>
            <a:ext cx="514885" cy="246221"/>
            <a:chOff x="2939991" y="6141223"/>
            <a:chExt cx="514885" cy="246221"/>
          </a:xfrm>
        </p:grpSpPr>
        <p:sp>
          <p:nvSpPr>
            <p:cNvPr id="24" name="Rectángulo 23"/>
            <p:cNvSpPr/>
            <p:nvPr/>
          </p:nvSpPr>
          <p:spPr>
            <a:xfrm>
              <a:off x="2981017" y="6150310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2939991" y="6141223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+D</a:t>
              </a:r>
            </a:p>
          </p:txBody>
        </p:sp>
      </p:grpSp>
      <p:grpSp>
        <p:nvGrpSpPr>
          <p:cNvPr id="26" name="Grupo 25"/>
          <p:cNvGrpSpPr/>
          <p:nvPr/>
        </p:nvGrpSpPr>
        <p:grpSpPr>
          <a:xfrm>
            <a:off x="4850965" y="4038503"/>
            <a:ext cx="405301" cy="246221"/>
            <a:chOff x="1986457" y="6135127"/>
            <a:chExt cx="405301" cy="246221"/>
          </a:xfrm>
        </p:grpSpPr>
        <p:sp>
          <p:nvSpPr>
            <p:cNvPr id="27" name="Rectángulo 26"/>
            <p:cNvSpPr/>
            <p:nvPr/>
          </p:nvSpPr>
          <p:spPr>
            <a:xfrm>
              <a:off x="1986457" y="6157026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1990323" y="6135127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N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Grupo 28"/>
          <p:cNvGrpSpPr/>
          <p:nvPr/>
        </p:nvGrpSpPr>
        <p:grpSpPr>
          <a:xfrm>
            <a:off x="5352872" y="4052782"/>
            <a:ext cx="405301" cy="246221"/>
            <a:chOff x="2472013" y="6141223"/>
            <a:chExt cx="405301" cy="246221"/>
          </a:xfrm>
        </p:grpSpPr>
        <p:sp>
          <p:nvSpPr>
            <p:cNvPr id="30" name="Rectángulo 29"/>
            <p:cNvSpPr/>
            <p:nvPr/>
          </p:nvSpPr>
          <p:spPr>
            <a:xfrm>
              <a:off x="2472013" y="6157025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CuadroTexto 30"/>
            <p:cNvSpPr txBox="1"/>
            <p:nvPr/>
          </p:nvSpPr>
          <p:spPr>
            <a:xfrm>
              <a:off x="2490195" y="6141223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Grupo 31"/>
          <p:cNvGrpSpPr/>
          <p:nvPr/>
        </p:nvGrpSpPr>
        <p:grpSpPr>
          <a:xfrm>
            <a:off x="5793704" y="4055269"/>
            <a:ext cx="514885" cy="246221"/>
            <a:chOff x="2939991" y="6141223"/>
            <a:chExt cx="514885" cy="246221"/>
          </a:xfrm>
        </p:grpSpPr>
        <p:sp>
          <p:nvSpPr>
            <p:cNvPr id="33" name="Rectángulo 32"/>
            <p:cNvSpPr/>
            <p:nvPr/>
          </p:nvSpPr>
          <p:spPr>
            <a:xfrm>
              <a:off x="2981017" y="6150310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2939991" y="6141223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+D</a:t>
              </a:r>
            </a:p>
          </p:txBody>
        </p:sp>
      </p:grpSp>
      <p:cxnSp>
        <p:nvCxnSpPr>
          <p:cNvPr id="35" name="Conector recto 34"/>
          <p:cNvCxnSpPr/>
          <p:nvPr/>
        </p:nvCxnSpPr>
        <p:spPr>
          <a:xfrm>
            <a:off x="1697088" y="219353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35"/>
          <p:cNvCxnSpPr/>
          <p:nvPr/>
        </p:nvCxnSpPr>
        <p:spPr>
          <a:xfrm>
            <a:off x="2197468" y="219353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36"/>
          <p:cNvCxnSpPr/>
          <p:nvPr/>
        </p:nvCxnSpPr>
        <p:spPr>
          <a:xfrm>
            <a:off x="2692768" y="219353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37"/>
          <p:cNvCxnSpPr/>
          <p:nvPr/>
        </p:nvCxnSpPr>
        <p:spPr>
          <a:xfrm>
            <a:off x="1697088" y="502207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ctor recto 38"/>
          <p:cNvCxnSpPr/>
          <p:nvPr/>
        </p:nvCxnSpPr>
        <p:spPr>
          <a:xfrm>
            <a:off x="2197468" y="502207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ctor recto 39"/>
          <p:cNvCxnSpPr/>
          <p:nvPr/>
        </p:nvCxnSpPr>
        <p:spPr>
          <a:xfrm>
            <a:off x="2692768" y="502207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40"/>
          <p:cNvCxnSpPr/>
          <p:nvPr/>
        </p:nvCxnSpPr>
        <p:spPr>
          <a:xfrm>
            <a:off x="4798428" y="219607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ctor recto 41"/>
          <p:cNvCxnSpPr/>
          <p:nvPr/>
        </p:nvCxnSpPr>
        <p:spPr>
          <a:xfrm>
            <a:off x="5298808" y="219607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42"/>
          <p:cNvCxnSpPr/>
          <p:nvPr/>
        </p:nvCxnSpPr>
        <p:spPr>
          <a:xfrm>
            <a:off x="5799188" y="219607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recto 43"/>
          <p:cNvCxnSpPr/>
          <p:nvPr/>
        </p:nvCxnSpPr>
        <p:spPr>
          <a:xfrm>
            <a:off x="4798428" y="50189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ctor recto 44"/>
          <p:cNvCxnSpPr/>
          <p:nvPr/>
        </p:nvCxnSpPr>
        <p:spPr>
          <a:xfrm>
            <a:off x="5298808" y="50189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ctor recto 45"/>
          <p:cNvCxnSpPr/>
          <p:nvPr/>
        </p:nvCxnSpPr>
        <p:spPr>
          <a:xfrm>
            <a:off x="5799188" y="50189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85048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2139210"/>
              </p:ext>
            </p:extLst>
          </p:nvPr>
        </p:nvGraphicFramePr>
        <p:xfrm>
          <a:off x="3598848" y="5351408"/>
          <a:ext cx="2772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áfico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7462854"/>
              </p:ext>
            </p:extLst>
          </p:nvPr>
        </p:nvGraphicFramePr>
        <p:xfrm>
          <a:off x="505926" y="5356078"/>
          <a:ext cx="2772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á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5418760"/>
              </p:ext>
            </p:extLst>
          </p:nvPr>
        </p:nvGraphicFramePr>
        <p:xfrm>
          <a:off x="506423" y="431638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3138774"/>
              </p:ext>
            </p:extLst>
          </p:nvPr>
        </p:nvGraphicFramePr>
        <p:xfrm>
          <a:off x="505926" y="2073852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Gráfic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1946332"/>
              </p:ext>
            </p:extLst>
          </p:nvPr>
        </p:nvGraphicFramePr>
        <p:xfrm>
          <a:off x="505926" y="3708544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Gráfico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8096956"/>
              </p:ext>
            </p:extLst>
          </p:nvPr>
        </p:nvGraphicFramePr>
        <p:xfrm>
          <a:off x="3598944" y="431638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Gráfico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4448951"/>
              </p:ext>
            </p:extLst>
          </p:nvPr>
        </p:nvGraphicFramePr>
        <p:xfrm>
          <a:off x="3592672" y="2076645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Gráfico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6103017"/>
              </p:ext>
            </p:extLst>
          </p:nvPr>
        </p:nvGraphicFramePr>
        <p:xfrm>
          <a:off x="3594644" y="3716066"/>
          <a:ext cx="27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0" name="CuadroTexto 9"/>
          <p:cNvSpPr txBox="1"/>
          <p:nvPr/>
        </p:nvSpPr>
        <p:spPr>
          <a:xfrm>
            <a:off x="1748321" y="229510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ELFS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4873300" y="230155"/>
            <a:ext cx="6703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NAL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 rot="16200000">
            <a:off x="-255773" y="1040151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rK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uadroTexto 12"/>
          <p:cNvSpPr txBox="1"/>
          <p:nvPr/>
        </p:nvSpPr>
        <p:spPr>
          <a:xfrm rot="16200000">
            <a:off x="2835209" y="1046143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rK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uadroTexto 13"/>
          <p:cNvSpPr txBox="1"/>
          <p:nvPr/>
        </p:nvSpPr>
        <p:spPr>
          <a:xfrm rot="16200000">
            <a:off x="-255773" y="2669952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rS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CuadroTexto 14"/>
          <p:cNvSpPr txBox="1"/>
          <p:nvPr/>
        </p:nvSpPr>
        <p:spPr>
          <a:xfrm rot="16200000">
            <a:off x="2835210" y="2677541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rS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CuadroTexto 15"/>
          <p:cNvSpPr txBox="1"/>
          <p:nvPr/>
        </p:nvSpPr>
        <p:spPr>
          <a:xfrm rot="16200000">
            <a:off x="-258913" y="4309160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sZI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CuadroTexto 16"/>
          <p:cNvSpPr txBox="1"/>
          <p:nvPr/>
        </p:nvSpPr>
        <p:spPr>
          <a:xfrm rot="16200000">
            <a:off x="2830242" y="4311518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sZI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CuadroTexto 17"/>
          <p:cNvSpPr txBox="1"/>
          <p:nvPr/>
        </p:nvSpPr>
        <p:spPr>
          <a:xfrm rot="16200000">
            <a:off x="-263878" y="5963329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sZII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uadroTexto 18"/>
          <p:cNvSpPr txBox="1"/>
          <p:nvPr/>
        </p:nvSpPr>
        <p:spPr>
          <a:xfrm rot="16200000">
            <a:off x="2830594" y="5964408"/>
            <a:ext cx="12153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sZII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</a:p>
          <a:p>
            <a:pPr algn="ctr"/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pies g</a:t>
            </a:r>
            <a:r>
              <a:rPr lang="es-ES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il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CuadroTexto 19"/>
          <p:cNvSpPr txBox="1"/>
          <p:nvPr/>
        </p:nvSpPr>
        <p:spPr>
          <a:xfrm>
            <a:off x="1120141" y="57251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CuadroTexto 20"/>
          <p:cNvSpPr txBox="1"/>
          <p:nvPr/>
        </p:nvSpPr>
        <p:spPr>
          <a:xfrm>
            <a:off x="4213378" y="57251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uadroTexto 21"/>
          <p:cNvSpPr txBox="1"/>
          <p:nvPr/>
        </p:nvSpPr>
        <p:spPr>
          <a:xfrm>
            <a:off x="1118101" y="222111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4206774" y="222319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uadroTexto 23"/>
          <p:cNvSpPr txBox="1"/>
          <p:nvPr/>
        </p:nvSpPr>
        <p:spPr>
          <a:xfrm>
            <a:off x="1124845" y="3855088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4206774" y="386418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uadroTexto 25"/>
          <p:cNvSpPr txBox="1"/>
          <p:nvPr/>
        </p:nvSpPr>
        <p:spPr>
          <a:xfrm>
            <a:off x="1118134" y="550170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/>
          <p:cNvSpPr txBox="1"/>
          <p:nvPr/>
        </p:nvSpPr>
        <p:spPr>
          <a:xfrm>
            <a:off x="4206774" y="5501705"/>
            <a:ext cx="2872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ángulo 27"/>
          <p:cNvSpPr/>
          <p:nvPr/>
        </p:nvSpPr>
        <p:spPr>
          <a:xfrm>
            <a:off x="140676" y="7899366"/>
            <a:ext cx="6223995" cy="14096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</a:t>
            </a: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2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bundance of denitrifying microorganisms expressed as </a:t>
            </a:r>
            <a:r>
              <a:rPr lang="en-GB" sz="10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irK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n-GB" sz="10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irS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n-GB" sz="10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sZI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GB" sz="10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sZII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ELFS 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, E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NAL (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,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, F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GB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BNI-isogenic-lines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cking BNI-trait (Control) and with BNI-trait (BNI). Wheat was fertilized with potassium nitrate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N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monium sulphate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mmonium sulphate + DMPP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+D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 differences between N treatments of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-isogenic-lines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 marked with a lowercase letter. Significant differences between N treatments of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NI-isogenic-lines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 marked with a capital letter. The Mann-Whitney U test was used for the comparison between the absence or the presence of BNI-trait within the same fertilization treatment and the significant differences at p &lt;0.05 are marked with an asterisk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*).</a:t>
            </a:r>
            <a:endParaRPr lang="es-E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9" name="Grupo 28"/>
          <p:cNvGrpSpPr/>
          <p:nvPr/>
        </p:nvGrpSpPr>
        <p:grpSpPr>
          <a:xfrm>
            <a:off x="1657388" y="7349233"/>
            <a:ext cx="405301" cy="246221"/>
            <a:chOff x="1986457" y="6135127"/>
            <a:chExt cx="405301" cy="246221"/>
          </a:xfrm>
        </p:grpSpPr>
        <p:sp>
          <p:nvSpPr>
            <p:cNvPr id="30" name="Rectángulo 29"/>
            <p:cNvSpPr/>
            <p:nvPr/>
          </p:nvSpPr>
          <p:spPr>
            <a:xfrm>
              <a:off x="1986457" y="6157026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CuadroTexto 30"/>
            <p:cNvSpPr txBox="1"/>
            <p:nvPr/>
          </p:nvSpPr>
          <p:spPr>
            <a:xfrm>
              <a:off x="1990323" y="6135127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N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Grupo 31"/>
          <p:cNvGrpSpPr/>
          <p:nvPr/>
        </p:nvGrpSpPr>
        <p:grpSpPr>
          <a:xfrm>
            <a:off x="2154320" y="7347605"/>
            <a:ext cx="405301" cy="246221"/>
            <a:chOff x="2472013" y="6141223"/>
            <a:chExt cx="405301" cy="246221"/>
          </a:xfrm>
        </p:grpSpPr>
        <p:sp>
          <p:nvSpPr>
            <p:cNvPr id="33" name="Rectángulo 32"/>
            <p:cNvSpPr/>
            <p:nvPr/>
          </p:nvSpPr>
          <p:spPr>
            <a:xfrm>
              <a:off x="2472013" y="6157025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2490195" y="6141223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5" name="Grupo 34"/>
          <p:cNvGrpSpPr/>
          <p:nvPr/>
        </p:nvGrpSpPr>
        <p:grpSpPr>
          <a:xfrm>
            <a:off x="2629283" y="7347833"/>
            <a:ext cx="514885" cy="246221"/>
            <a:chOff x="2939991" y="6141223"/>
            <a:chExt cx="514885" cy="246221"/>
          </a:xfrm>
        </p:grpSpPr>
        <p:sp>
          <p:nvSpPr>
            <p:cNvPr id="36" name="Rectángulo 35"/>
            <p:cNvSpPr/>
            <p:nvPr/>
          </p:nvSpPr>
          <p:spPr>
            <a:xfrm>
              <a:off x="2981017" y="6150310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2939991" y="6141223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+D</a:t>
              </a:r>
            </a:p>
          </p:txBody>
        </p:sp>
      </p:grpSp>
      <p:grpSp>
        <p:nvGrpSpPr>
          <p:cNvPr id="38" name="Grupo 37"/>
          <p:cNvGrpSpPr/>
          <p:nvPr/>
        </p:nvGrpSpPr>
        <p:grpSpPr>
          <a:xfrm>
            <a:off x="4758936" y="7349005"/>
            <a:ext cx="405301" cy="246221"/>
            <a:chOff x="1986457" y="6135127"/>
            <a:chExt cx="405301" cy="246221"/>
          </a:xfrm>
        </p:grpSpPr>
        <p:sp>
          <p:nvSpPr>
            <p:cNvPr id="39" name="Rectángulo 38"/>
            <p:cNvSpPr/>
            <p:nvPr/>
          </p:nvSpPr>
          <p:spPr>
            <a:xfrm>
              <a:off x="1986457" y="6157026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1990323" y="6135127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N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1" name="Grupo 40"/>
          <p:cNvGrpSpPr/>
          <p:nvPr/>
        </p:nvGrpSpPr>
        <p:grpSpPr>
          <a:xfrm>
            <a:off x="5255868" y="7347377"/>
            <a:ext cx="405301" cy="246221"/>
            <a:chOff x="2472013" y="6141223"/>
            <a:chExt cx="405301" cy="246221"/>
          </a:xfrm>
        </p:grpSpPr>
        <p:sp>
          <p:nvSpPr>
            <p:cNvPr id="42" name="Rectángulo 41"/>
            <p:cNvSpPr/>
            <p:nvPr/>
          </p:nvSpPr>
          <p:spPr>
            <a:xfrm>
              <a:off x="2472013" y="6157025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2490195" y="6141223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</a:t>
              </a:r>
              <a:endPara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4" name="Grupo 43"/>
          <p:cNvGrpSpPr/>
          <p:nvPr/>
        </p:nvGrpSpPr>
        <p:grpSpPr>
          <a:xfrm>
            <a:off x="5730831" y="7347605"/>
            <a:ext cx="514885" cy="246221"/>
            <a:chOff x="2939991" y="6141223"/>
            <a:chExt cx="514885" cy="246221"/>
          </a:xfrm>
        </p:grpSpPr>
        <p:sp>
          <p:nvSpPr>
            <p:cNvPr id="45" name="Rectángulo 44"/>
            <p:cNvSpPr/>
            <p:nvPr/>
          </p:nvSpPr>
          <p:spPr>
            <a:xfrm>
              <a:off x="2981017" y="6150310"/>
              <a:ext cx="405301" cy="187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2939991" y="6141223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+D</a:t>
              </a:r>
            </a:p>
          </p:txBody>
        </p:sp>
      </p:grpSp>
      <p:cxnSp>
        <p:nvCxnSpPr>
          <p:cNvPr id="47" name="Conector recto 46"/>
          <p:cNvCxnSpPr/>
          <p:nvPr/>
        </p:nvCxnSpPr>
        <p:spPr>
          <a:xfrm>
            <a:off x="1638007" y="54987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47"/>
          <p:cNvCxnSpPr/>
          <p:nvPr/>
        </p:nvCxnSpPr>
        <p:spPr>
          <a:xfrm>
            <a:off x="2137117" y="54987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>
            <a:off x="2636862" y="54987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>
            <a:off x="4731727" y="549714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/>
          <p:cNvCxnSpPr/>
          <p:nvPr/>
        </p:nvCxnSpPr>
        <p:spPr>
          <a:xfrm>
            <a:off x="5230837" y="549714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cto 51"/>
          <p:cNvCxnSpPr/>
          <p:nvPr/>
        </p:nvCxnSpPr>
        <p:spPr>
          <a:xfrm>
            <a:off x="5730582" y="549714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52"/>
          <p:cNvCxnSpPr/>
          <p:nvPr/>
        </p:nvCxnSpPr>
        <p:spPr>
          <a:xfrm>
            <a:off x="1638007" y="38477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ector recto 53"/>
          <p:cNvCxnSpPr/>
          <p:nvPr/>
        </p:nvCxnSpPr>
        <p:spPr>
          <a:xfrm>
            <a:off x="2137117" y="38477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54"/>
          <p:cNvCxnSpPr/>
          <p:nvPr/>
        </p:nvCxnSpPr>
        <p:spPr>
          <a:xfrm>
            <a:off x="2636862" y="38477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ector recto 55"/>
          <p:cNvCxnSpPr/>
          <p:nvPr/>
        </p:nvCxnSpPr>
        <p:spPr>
          <a:xfrm>
            <a:off x="1638007" y="221196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56"/>
          <p:cNvCxnSpPr/>
          <p:nvPr/>
        </p:nvCxnSpPr>
        <p:spPr>
          <a:xfrm>
            <a:off x="2137117" y="221196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ector recto 57"/>
          <p:cNvCxnSpPr/>
          <p:nvPr/>
        </p:nvCxnSpPr>
        <p:spPr>
          <a:xfrm>
            <a:off x="2636862" y="221196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ector recto 58"/>
          <p:cNvCxnSpPr/>
          <p:nvPr/>
        </p:nvCxnSpPr>
        <p:spPr>
          <a:xfrm>
            <a:off x="1638007" y="5711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ector recto 59"/>
          <p:cNvCxnSpPr/>
          <p:nvPr/>
        </p:nvCxnSpPr>
        <p:spPr>
          <a:xfrm>
            <a:off x="2137117" y="5711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ector recto 60"/>
          <p:cNvCxnSpPr/>
          <p:nvPr/>
        </p:nvCxnSpPr>
        <p:spPr>
          <a:xfrm>
            <a:off x="2636862" y="57112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ector recto 61"/>
          <p:cNvCxnSpPr/>
          <p:nvPr/>
        </p:nvCxnSpPr>
        <p:spPr>
          <a:xfrm>
            <a:off x="4739870" y="385376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ector recto 62"/>
          <p:cNvCxnSpPr/>
          <p:nvPr/>
        </p:nvCxnSpPr>
        <p:spPr>
          <a:xfrm>
            <a:off x="5238980" y="385376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ector recto 63"/>
          <p:cNvCxnSpPr/>
          <p:nvPr/>
        </p:nvCxnSpPr>
        <p:spPr>
          <a:xfrm>
            <a:off x="5730582" y="385376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ector recto 64"/>
          <p:cNvCxnSpPr/>
          <p:nvPr/>
        </p:nvCxnSpPr>
        <p:spPr>
          <a:xfrm>
            <a:off x="4739870" y="221800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ector recto 65"/>
          <p:cNvCxnSpPr/>
          <p:nvPr/>
        </p:nvCxnSpPr>
        <p:spPr>
          <a:xfrm>
            <a:off x="5238980" y="221800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ector recto 66"/>
          <p:cNvCxnSpPr/>
          <p:nvPr/>
        </p:nvCxnSpPr>
        <p:spPr>
          <a:xfrm>
            <a:off x="5730582" y="2218001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ector recto 67"/>
          <p:cNvCxnSpPr/>
          <p:nvPr/>
        </p:nvCxnSpPr>
        <p:spPr>
          <a:xfrm>
            <a:off x="4739870" y="57308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ector recto 68"/>
          <p:cNvCxnSpPr/>
          <p:nvPr/>
        </p:nvCxnSpPr>
        <p:spPr>
          <a:xfrm>
            <a:off x="5238980" y="57308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ector recto 69"/>
          <p:cNvCxnSpPr/>
          <p:nvPr/>
        </p:nvCxnSpPr>
        <p:spPr>
          <a:xfrm>
            <a:off x="5730582" y="573084"/>
            <a:ext cx="0" cy="133200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67765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0</TotalTime>
  <Words>694</Words>
  <Application>Microsoft Office PowerPoint</Application>
  <PresentationFormat>A4 (210 x 297 mm)</PresentationFormat>
  <Paragraphs>202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rian BOZAL</dc:creator>
  <cp:lastModifiedBy>Adrian BOZAL</cp:lastModifiedBy>
  <cp:revision>101</cp:revision>
  <dcterms:created xsi:type="dcterms:W3CDTF">2022-03-16T18:46:26Z</dcterms:created>
  <dcterms:modified xsi:type="dcterms:W3CDTF">2022-10-10T10:46:12Z</dcterms:modified>
</cp:coreProperties>
</file>